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handoutMasterIdLst>
    <p:handoutMasterId r:id="rId8"/>
  </p:handoutMasterIdLst>
  <p:sldIdLst>
    <p:sldId id="296" r:id="rId2"/>
    <p:sldId id="376" r:id="rId3"/>
    <p:sldId id="418" r:id="rId4"/>
    <p:sldId id="420" r:id="rId5"/>
    <p:sldId id="421" r:id="rId6"/>
  </p:sldIdLst>
  <p:sldSz cx="10691813" cy="43200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F3F3"/>
    <a:srgbClr val="FBFBFB"/>
    <a:srgbClr val="F0EBF3"/>
    <a:srgbClr val="00F011"/>
    <a:srgbClr val="942093"/>
    <a:srgbClr val="9C24A2"/>
    <a:srgbClr val="DDE1F0"/>
    <a:srgbClr val="F0EBF2"/>
    <a:srgbClr val="FDEEED"/>
    <a:srgbClr val="C230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DB641B5-C776-4797-A14E-1C76DC2A91ED}" v="4" dt="2026-01-21T10:07:21.51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63" autoAdjust="0"/>
    <p:restoredTop sz="95909" autoAdjust="0"/>
  </p:normalViewPr>
  <p:slideViewPr>
    <p:cSldViewPr snapToGrid="0">
      <p:cViewPr>
        <p:scale>
          <a:sx n="50" d="100"/>
          <a:sy n="50" d="100"/>
        </p:scale>
        <p:origin x="3312" y="-408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30" d="100"/>
        <a:sy n="13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73" d="100"/>
          <a:sy n="73" d="100"/>
        </p:scale>
        <p:origin x="2694" y="21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mon Melderis" userId="ca78939aff0d82b1" providerId="LiveId" clId="{D03A1E44-15A7-4C5D-BCC3-8E3FD138D489}"/>
    <pc:docChg chg="delSld modSld modMainMaster modNotesMaster">
      <pc:chgData name="Simon Melderis" userId="ca78939aff0d82b1" providerId="LiveId" clId="{D03A1E44-15A7-4C5D-BCC3-8E3FD138D489}" dt="2026-01-21T10:08:45.240" v="119" actId="1076"/>
      <pc:docMkLst>
        <pc:docMk/>
      </pc:docMkLst>
      <pc:sldChg chg="addSp modSp mod modNotes">
        <pc:chgData name="Simon Melderis" userId="ca78939aff0d82b1" providerId="LiveId" clId="{D03A1E44-15A7-4C5D-BCC3-8E3FD138D489}" dt="2026-01-21T10:07:56.344" v="83" actId="1076"/>
        <pc:sldMkLst>
          <pc:docMk/>
          <pc:sldMk cId="379575056" sldId="296"/>
        </pc:sldMkLst>
        <pc:spChg chg="add mod">
          <ac:chgData name="Simon Melderis" userId="ca78939aff0d82b1" providerId="LiveId" clId="{D03A1E44-15A7-4C5D-BCC3-8E3FD138D489}" dt="2026-01-21T10:07:56.344" v="83" actId="1076"/>
          <ac:spMkLst>
            <pc:docMk/>
            <pc:sldMk cId="379575056" sldId="296"/>
            <ac:spMk id="3" creationId="{F3609B8A-65D6-5B73-8BE1-9F3476A50836}"/>
          </ac:spMkLst>
        </pc:spChg>
        <pc:graphicFrameChg chg="mod">
          <ac:chgData name="Simon Melderis" userId="ca78939aff0d82b1" providerId="LiveId" clId="{D03A1E44-15A7-4C5D-BCC3-8E3FD138D489}" dt="2026-01-21T10:07:53.133" v="82" actId="1076"/>
          <ac:graphicFrameMkLst>
            <pc:docMk/>
            <pc:sldMk cId="379575056" sldId="296"/>
            <ac:graphicFrameMk id="4" creationId="{FDCD21B6-1C14-8462-8AF0-159D6ADBC18B}"/>
          </ac:graphicFrameMkLst>
        </pc:graphicFrameChg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3299717931" sldId="375"/>
        </pc:sldMkLst>
      </pc:sldChg>
      <pc:sldChg chg="addSp modSp mod">
        <pc:chgData name="Simon Melderis" userId="ca78939aff0d82b1" providerId="LiveId" clId="{D03A1E44-15A7-4C5D-BCC3-8E3FD138D489}" dt="2026-01-21T10:07:44.111" v="80" actId="1076"/>
        <pc:sldMkLst>
          <pc:docMk/>
          <pc:sldMk cId="3916763852" sldId="376"/>
        </pc:sldMkLst>
        <pc:spChg chg="add mod">
          <ac:chgData name="Simon Melderis" userId="ca78939aff0d82b1" providerId="LiveId" clId="{D03A1E44-15A7-4C5D-BCC3-8E3FD138D489}" dt="2026-01-21T10:07:44.111" v="80" actId="1076"/>
          <ac:spMkLst>
            <pc:docMk/>
            <pc:sldMk cId="3916763852" sldId="376"/>
            <ac:spMk id="3" creationId="{CB0136A8-CA90-B53E-C1FB-EFECB85B4993}"/>
          </ac:spMkLst>
        </pc:spChg>
        <pc:graphicFrameChg chg="mod">
          <ac:chgData name="Simon Melderis" userId="ca78939aff0d82b1" providerId="LiveId" clId="{D03A1E44-15A7-4C5D-BCC3-8E3FD138D489}" dt="2026-01-21T10:07:40.475" v="79" actId="1076"/>
          <ac:graphicFrameMkLst>
            <pc:docMk/>
            <pc:sldMk cId="3916763852" sldId="376"/>
            <ac:graphicFrameMk id="4" creationId="{18A0E4EA-398D-37ED-F6DC-8FB6FEEF2A9C}"/>
          </ac:graphicFrameMkLst>
        </pc:graphicFrameChg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36388580" sldId="385"/>
        </pc:sldMkLst>
      </pc:sldChg>
      <pc:sldChg chg="addSp modSp mod">
        <pc:chgData name="Simon Melderis" userId="ca78939aff0d82b1" providerId="LiveId" clId="{D03A1E44-15A7-4C5D-BCC3-8E3FD138D489}" dt="2026-01-21T10:08:11.504" v="85" actId="1076"/>
        <pc:sldMkLst>
          <pc:docMk/>
          <pc:sldMk cId="698288533" sldId="418"/>
        </pc:sldMkLst>
        <pc:spChg chg="add mod">
          <ac:chgData name="Simon Melderis" userId="ca78939aff0d82b1" providerId="LiveId" clId="{D03A1E44-15A7-4C5D-BCC3-8E3FD138D489}" dt="2026-01-21T10:08:11.504" v="85" actId="1076"/>
          <ac:spMkLst>
            <pc:docMk/>
            <pc:sldMk cId="698288533" sldId="418"/>
            <ac:spMk id="3" creationId="{C1ACDEF0-9784-BEC1-8D2A-08A581158FAB}"/>
          </ac:spMkLst>
        </pc:spChg>
        <pc:graphicFrameChg chg="mod">
          <ac:chgData name="Simon Melderis" userId="ca78939aff0d82b1" providerId="LiveId" clId="{D03A1E44-15A7-4C5D-BCC3-8E3FD138D489}" dt="2026-01-21T10:08:09.060" v="84" actId="1076"/>
          <ac:graphicFrameMkLst>
            <pc:docMk/>
            <pc:sldMk cId="698288533" sldId="418"/>
            <ac:graphicFrameMk id="6" creationId="{BE778A08-D0ED-D9B9-D99A-0324FE629529}"/>
          </ac:graphicFrameMkLst>
        </pc:graphicFrameChg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3846161335" sldId="419"/>
        </pc:sldMkLst>
      </pc:sldChg>
      <pc:sldChg chg="addSp modSp mod">
        <pc:chgData name="Simon Melderis" userId="ca78939aff0d82b1" providerId="LiveId" clId="{D03A1E44-15A7-4C5D-BCC3-8E3FD138D489}" dt="2026-01-21T10:07:33.670" v="78" actId="14100"/>
        <pc:sldMkLst>
          <pc:docMk/>
          <pc:sldMk cId="2203907726" sldId="420"/>
        </pc:sldMkLst>
        <pc:spChg chg="add mod">
          <ac:chgData name="Simon Melderis" userId="ca78939aff0d82b1" providerId="LiveId" clId="{D03A1E44-15A7-4C5D-BCC3-8E3FD138D489}" dt="2026-01-21T10:07:33.670" v="78" actId="14100"/>
          <ac:spMkLst>
            <pc:docMk/>
            <pc:sldMk cId="2203907726" sldId="420"/>
            <ac:spMk id="3" creationId="{C3AB88C6-822B-60B1-32C2-242EFBB7CFB1}"/>
          </ac:spMkLst>
        </pc:spChg>
        <pc:graphicFrameChg chg="mod">
          <ac:chgData name="Simon Melderis" userId="ca78939aff0d82b1" providerId="LiveId" clId="{D03A1E44-15A7-4C5D-BCC3-8E3FD138D489}" dt="2026-01-21T10:07:25.611" v="76" actId="1076"/>
          <ac:graphicFrameMkLst>
            <pc:docMk/>
            <pc:sldMk cId="2203907726" sldId="420"/>
            <ac:graphicFrameMk id="9" creationId="{EED4D1AB-FCD1-9C20-8A54-FEC003FE5797}"/>
          </ac:graphicFrameMkLst>
        </pc:graphicFrameChg>
      </pc:sldChg>
      <pc:sldChg chg="addSp modSp mod">
        <pc:chgData name="Simon Melderis" userId="ca78939aff0d82b1" providerId="LiveId" clId="{D03A1E44-15A7-4C5D-BCC3-8E3FD138D489}" dt="2026-01-21T10:08:45.240" v="119" actId="1076"/>
        <pc:sldMkLst>
          <pc:docMk/>
          <pc:sldMk cId="3625836125" sldId="421"/>
        </pc:sldMkLst>
        <pc:spChg chg="add mod">
          <ac:chgData name="Simon Melderis" userId="ca78939aff0d82b1" providerId="LiveId" clId="{D03A1E44-15A7-4C5D-BCC3-8E3FD138D489}" dt="2026-01-21T10:08:45.240" v="119" actId="1076"/>
          <ac:spMkLst>
            <pc:docMk/>
            <pc:sldMk cId="3625836125" sldId="421"/>
            <ac:spMk id="3" creationId="{FCADB1D0-AA34-533B-FE12-52A9CC808F7F}"/>
          </ac:spMkLst>
        </pc:spChg>
        <pc:spChg chg="mod">
          <ac:chgData name="Simon Melderis" userId="ca78939aff0d82b1" providerId="LiveId" clId="{D03A1E44-15A7-4C5D-BCC3-8E3FD138D489}" dt="2026-01-21T10:08:18.568" v="86" actId="1076"/>
          <ac:spMkLst>
            <pc:docMk/>
            <pc:sldMk cId="3625836125" sldId="421"/>
            <ac:spMk id="8" creationId="{96BF55C2-32CF-DD70-E765-468062CDE4E9}"/>
          </ac:spMkLst>
        </pc:spChg>
        <pc:spChg chg="mod">
          <ac:chgData name="Simon Melderis" userId="ca78939aff0d82b1" providerId="LiveId" clId="{D03A1E44-15A7-4C5D-BCC3-8E3FD138D489}" dt="2026-01-21T10:08:25.146" v="113" actId="1038"/>
          <ac:spMkLst>
            <pc:docMk/>
            <pc:sldMk cId="3625836125" sldId="421"/>
            <ac:spMk id="57" creationId="{FDA0B653-AC83-4C51-B83E-375410C4551F}"/>
          </ac:spMkLst>
        </pc:spChg>
        <pc:spChg chg="mod">
          <ac:chgData name="Simon Melderis" userId="ca78939aff0d82b1" providerId="LiveId" clId="{D03A1E44-15A7-4C5D-BCC3-8E3FD138D489}" dt="2026-01-21T10:08:25.146" v="113" actId="1038"/>
          <ac:spMkLst>
            <pc:docMk/>
            <pc:sldMk cId="3625836125" sldId="421"/>
            <ac:spMk id="58" creationId="{5185E552-BEE2-4AE0-9281-5AB191A50F55}"/>
          </ac:spMkLst>
        </pc:spChg>
        <pc:spChg chg="mod">
          <ac:chgData name="Simon Melderis" userId="ca78939aff0d82b1" providerId="LiveId" clId="{D03A1E44-15A7-4C5D-BCC3-8E3FD138D489}" dt="2026-01-21T10:08:25.146" v="113" actId="1038"/>
          <ac:spMkLst>
            <pc:docMk/>
            <pc:sldMk cId="3625836125" sldId="421"/>
            <ac:spMk id="101" creationId="{E1E00257-7572-440B-BA95-E09303807F26}"/>
          </ac:spMkLst>
        </pc:spChg>
        <pc:picChg chg="mod">
          <ac:chgData name="Simon Melderis" userId="ca78939aff0d82b1" providerId="LiveId" clId="{D03A1E44-15A7-4C5D-BCC3-8E3FD138D489}" dt="2026-01-21T10:08:25.146" v="113" actId="1038"/>
          <ac:picMkLst>
            <pc:docMk/>
            <pc:sldMk cId="3625836125" sldId="421"/>
            <ac:picMk id="100" creationId="{FB014317-222A-4B2D-BCF6-186DC0AE3F6E}"/>
          </ac:picMkLst>
        </pc:pic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66" creationId="{EC82533E-6CE8-464D-B78A-5475803BE5BB}"/>
          </ac:cxnSpMkLst>
        </pc:cxn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69" creationId="{C46BC46F-8C5E-4C8F-B254-67538D172CAE}"/>
          </ac:cxnSpMkLst>
        </pc:cxn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85" creationId="{0A769BDF-A5EC-4B3A-A0C4-6C3A772B7681}"/>
          </ac:cxnSpMkLst>
        </pc:cxn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87" creationId="{B855EF26-2A36-4CC0-8973-FEF51E6165E5}"/>
          </ac:cxnSpMkLst>
        </pc:cxn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93" creationId="{80E16BF9-53DB-4D28-80BC-788DFEE79676}"/>
          </ac:cxnSpMkLst>
        </pc:cxnChg>
        <pc:cxnChg chg="mod">
          <ac:chgData name="Simon Melderis" userId="ca78939aff0d82b1" providerId="LiveId" clId="{D03A1E44-15A7-4C5D-BCC3-8E3FD138D489}" dt="2026-01-21T10:08:25.146" v="113" actId="1038"/>
          <ac:cxnSpMkLst>
            <pc:docMk/>
            <pc:sldMk cId="3625836125" sldId="421"/>
            <ac:cxnSpMk id="97" creationId="{ED85E8DD-F8BD-40D9-B3AD-1C5748639900}"/>
          </ac:cxnSpMkLst>
        </pc:cxnChg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1758632765" sldId="425"/>
        </pc:sldMkLst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2625213908" sldId="427"/>
        </pc:sldMkLst>
      </pc:sldChg>
      <pc:sldChg chg="del">
        <pc:chgData name="Simon Melderis" userId="ca78939aff0d82b1" providerId="LiveId" clId="{D03A1E44-15A7-4C5D-BCC3-8E3FD138D489}" dt="2026-01-21T10:03:18.322" v="0" actId="47"/>
        <pc:sldMkLst>
          <pc:docMk/>
          <pc:sldMk cId="1133148539" sldId="428"/>
        </pc:sldMkLst>
      </pc:sldChg>
      <pc:sldMasterChg chg="modSp modSldLayout">
        <pc:chgData name="Simon Melderis" userId="ca78939aff0d82b1" providerId="LiveId" clId="{D03A1E44-15A7-4C5D-BCC3-8E3FD138D489}" dt="2026-01-21T10:05:37.370" v="53"/>
        <pc:sldMasterMkLst>
          <pc:docMk/>
          <pc:sldMasterMk cId="3393557459" sldId="2147483648"/>
        </pc:sldMasterMkLst>
        <pc:spChg chg="mod">
          <ac:chgData name="Simon Melderis" userId="ca78939aff0d82b1" providerId="LiveId" clId="{D03A1E44-15A7-4C5D-BCC3-8E3FD138D489}" dt="2026-01-21T10:05:37.370" v="53"/>
          <ac:spMkLst>
            <pc:docMk/>
            <pc:sldMasterMk cId="3393557459" sldId="2147483648"/>
            <ac:spMk id="2" creationId="{73873967-6289-9D9A-A6CD-656E81745D17}"/>
          </ac:spMkLst>
        </pc:spChg>
        <pc:spChg chg="mod">
          <ac:chgData name="Simon Melderis" userId="ca78939aff0d82b1" providerId="LiveId" clId="{D03A1E44-15A7-4C5D-BCC3-8E3FD138D489}" dt="2026-01-21T10:05:37.370" v="53"/>
          <ac:spMkLst>
            <pc:docMk/>
            <pc:sldMasterMk cId="3393557459" sldId="2147483648"/>
            <ac:spMk id="3" creationId="{41317721-0C02-7F13-5D65-354EF8D91320}"/>
          </ac:spMkLst>
        </pc:spChg>
        <pc:spChg chg="mod">
          <ac:chgData name="Simon Melderis" userId="ca78939aff0d82b1" providerId="LiveId" clId="{D03A1E44-15A7-4C5D-BCC3-8E3FD138D489}" dt="2026-01-21T10:05:37.370" v="53"/>
          <ac:spMkLst>
            <pc:docMk/>
            <pc:sldMasterMk cId="3393557459" sldId="2147483648"/>
            <ac:spMk id="4" creationId="{6FCD9E3E-EA96-88DD-C841-33FCF21CD626}"/>
          </ac:spMkLst>
        </pc:spChg>
        <pc:spChg chg="mod">
          <ac:chgData name="Simon Melderis" userId="ca78939aff0d82b1" providerId="LiveId" clId="{D03A1E44-15A7-4C5D-BCC3-8E3FD138D489}" dt="2026-01-21T10:05:37.370" v="53"/>
          <ac:spMkLst>
            <pc:docMk/>
            <pc:sldMasterMk cId="3393557459" sldId="2147483648"/>
            <ac:spMk id="5" creationId="{94959FE7-BA0C-F619-F8CE-1A9900C7C382}"/>
          </ac:spMkLst>
        </pc:spChg>
        <pc:spChg chg="mod">
          <ac:chgData name="Simon Melderis" userId="ca78939aff0d82b1" providerId="LiveId" clId="{D03A1E44-15A7-4C5D-BCC3-8E3FD138D489}" dt="2026-01-21T10:05:37.370" v="53"/>
          <ac:spMkLst>
            <pc:docMk/>
            <pc:sldMasterMk cId="3393557459" sldId="2147483648"/>
            <ac:spMk id="6" creationId="{81E163EC-9FB1-A2E8-3D86-55624B3ECA89}"/>
          </ac:spMkLst>
        </pc:sp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3843937371" sldId="2147483649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843937371" sldId="2147483649"/>
              <ac:spMk id="2" creationId="{D2900B5E-2468-1404-169F-5FE1C352E13B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843937371" sldId="2147483649"/>
              <ac:spMk id="3" creationId="{1CB8D166-F882-1074-D0F6-D929BC1B1252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38445718" sldId="2147483651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8445718" sldId="2147483651"/>
              <ac:spMk id="2" creationId="{4F89AC8E-0294-51E4-5EBC-9CA328CCD277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8445718" sldId="2147483651"/>
              <ac:spMk id="3" creationId="{E9ECA2B7-59E9-C1DE-3F18-56C8C2170D9F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2677844506" sldId="2147483652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2677844506" sldId="2147483652"/>
              <ac:spMk id="3" creationId="{EB722D96-C43D-F637-1B54-2D02EE3A001C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2677844506" sldId="2147483652"/>
              <ac:spMk id="4" creationId="{AF4A792C-25C1-A3BF-D628-6F43579456BF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498794388" sldId="2147483653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498794388" sldId="2147483653"/>
              <ac:spMk id="2" creationId="{D5698B9C-2F8E-DF87-CE68-234F27A6E655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498794388" sldId="2147483653"/>
              <ac:spMk id="3" creationId="{53AFB41E-8EC5-5CA9-34A9-B68627606583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498794388" sldId="2147483653"/>
              <ac:spMk id="4" creationId="{9CB0BC10-FFF7-AAB8-55EC-F1B612A85C05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498794388" sldId="2147483653"/>
              <ac:spMk id="5" creationId="{8F377811-C000-5C81-2CA9-971CC65D5DBA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498794388" sldId="2147483653"/>
              <ac:spMk id="6" creationId="{2C490148-230E-513D-A307-90B8F8EA9D3B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2809790608" sldId="2147483656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2809790608" sldId="2147483656"/>
              <ac:spMk id="2" creationId="{F303A507-BFFB-EC34-1EB3-491A95188FA4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2809790608" sldId="2147483656"/>
              <ac:spMk id="3" creationId="{8C290ACC-6B9E-7388-FCBD-BF9F5B93A5DE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2809790608" sldId="2147483656"/>
              <ac:spMk id="4" creationId="{3745CA95-F18E-B32D-05F4-A32777FDFEEC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360027543" sldId="2147483657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60027543" sldId="2147483657"/>
              <ac:spMk id="2" creationId="{D7E5D20A-B827-004C-F0BF-A137685B5E58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60027543" sldId="2147483657"/>
              <ac:spMk id="3" creationId="{91AE9BCD-320F-D3AC-A7C3-66E69A067079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60027543" sldId="2147483657"/>
              <ac:spMk id="4" creationId="{8569C810-322D-1D24-0EC0-005B40341D7D}"/>
            </ac:spMkLst>
          </pc:spChg>
        </pc:sldLayoutChg>
        <pc:sldLayoutChg chg="modSp">
          <pc:chgData name="Simon Melderis" userId="ca78939aff0d82b1" providerId="LiveId" clId="{D03A1E44-15A7-4C5D-BCC3-8E3FD138D489}" dt="2026-01-21T10:05:37.370" v="53"/>
          <pc:sldLayoutMkLst>
            <pc:docMk/>
            <pc:sldMasterMk cId="3393557459" sldId="2147483648"/>
            <pc:sldLayoutMk cId="3464820523" sldId="2147483659"/>
          </pc:sldLayoutMkLst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464820523" sldId="2147483659"/>
              <ac:spMk id="2" creationId="{75A92AC6-F363-A87B-F621-25D995470505}"/>
            </ac:spMkLst>
          </pc:spChg>
          <pc:spChg chg="mod">
            <ac:chgData name="Simon Melderis" userId="ca78939aff0d82b1" providerId="LiveId" clId="{D03A1E44-15A7-4C5D-BCC3-8E3FD138D489}" dt="2026-01-21T10:05:37.370" v="53"/>
            <ac:spMkLst>
              <pc:docMk/>
              <pc:sldMasterMk cId="3393557459" sldId="2147483648"/>
              <pc:sldLayoutMk cId="3464820523" sldId="2147483659"/>
              <ac:spMk id="3" creationId="{AAA3EB15-2D43-D81F-54B0-991A15621076}"/>
            </ac:spMkLst>
          </pc:spChg>
        </pc:sldLayoutChg>
      </pc:sldMaster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6E1BF3B6-67AF-2B26-D2D0-CBB6E6E9AB2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3922AA0-FF1F-C46C-EF78-25531B48837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57AB7-FB7E-4AE6-A6C3-F31A3213203C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42D7F36-8B92-A78B-6D38-C93605FABE3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E08E1DB-212A-7456-D487-86696FC05B6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7D469-983D-45EB-B228-9C28C52CAF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6784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0BF6A4-6EE5-3E4B-81D5-4F02C0336332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046413" y="1143000"/>
            <a:ext cx="765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CA07F3-E49B-8647-BE86-22846B847CB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9203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3046413" y="1143000"/>
            <a:ext cx="7651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CA07F3-E49B-8647-BE86-22846B847CB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0526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886" y="7070108"/>
            <a:ext cx="9088041" cy="15040222"/>
          </a:xfrm>
        </p:spPr>
        <p:txBody>
          <a:bodyPr anchor="b"/>
          <a:lstStyle>
            <a:lvl1pPr algn="ctr">
              <a:defRPr sz="70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6477" y="22690338"/>
            <a:ext cx="8018860" cy="10430151"/>
          </a:xfrm>
        </p:spPr>
        <p:txBody>
          <a:bodyPr/>
          <a:lstStyle>
            <a:lvl1pPr marL="0" indent="0" algn="ctr">
              <a:buNone/>
              <a:defRPr sz="2806"/>
            </a:lvl1pPr>
            <a:lvl2pPr marL="534604" indent="0" algn="ctr">
              <a:buNone/>
              <a:defRPr sz="2339"/>
            </a:lvl2pPr>
            <a:lvl3pPr marL="1069208" indent="0" algn="ctr">
              <a:buNone/>
              <a:defRPr sz="2105"/>
            </a:lvl3pPr>
            <a:lvl4pPr marL="1603812" indent="0" algn="ctr">
              <a:buNone/>
              <a:defRPr sz="1871"/>
            </a:lvl4pPr>
            <a:lvl5pPr marL="2138416" indent="0" algn="ctr">
              <a:buNone/>
              <a:defRPr sz="1871"/>
            </a:lvl5pPr>
            <a:lvl6pPr marL="2673020" indent="0" algn="ctr">
              <a:buNone/>
              <a:defRPr sz="1871"/>
            </a:lvl6pPr>
            <a:lvl7pPr marL="3207624" indent="0" algn="ctr">
              <a:buNone/>
              <a:defRPr sz="1871"/>
            </a:lvl7pPr>
            <a:lvl8pPr marL="3742228" indent="0" algn="ctr">
              <a:buNone/>
              <a:defRPr sz="1871"/>
            </a:lvl8pPr>
            <a:lvl9pPr marL="4276832" indent="0" algn="ctr">
              <a:buNone/>
              <a:defRPr sz="1871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590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9422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51329" y="2300034"/>
            <a:ext cx="2305422" cy="36610544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5063" y="2300034"/>
            <a:ext cx="6782619" cy="3661054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8379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571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494" y="10770172"/>
            <a:ext cx="9221689" cy="17970262"/>
          </a:xfrm>
        </p:spPr>
        <p:txBody>
          <a:bodyPr anchor="b"/>
          <a:lstStyle>
            <a:lvl1pPr>
              <a:defRPr sz="70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9494" y="28910440"/>
            <a:ext cx="9221689" cy="9450136"/>
          </a:xfrm>
        </p:spPr>
        <p:txBody>
          <a:bodyPr/>
          <a:lstStyle>
            <a:lvl1pPr marL="0" indent="0">
              <a:buNone/>
              <a:defRPr sz="2806">
                <a:solidFill>
                  <a:schemeClr val="tx1"/>
                </a:solidFill>
              </a:defRPr>
            </a:lvl1pPr>
            <a:lvl2pPr marL="534604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208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3812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8416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302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7624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2228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6832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6205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5062" y="11500170"/>
            <a:ext cx="4544021" cy="2741040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12730" y="11500170"/>
            <a:ext cx="4544021" cy="2741040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153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2300044"/>
            <a:ext cx="9221689" cy="835012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456" y="10590160"/>
            <a:ext cx="4523137" cy="5190073"/>
          </a:xfrm>
        </p:spPr>
        <p:txBody>
          <a:bodyPr anchor="b"/>
          <a:lstStyle>
            <a:lvl1pPr marL="0" indent="0">
              <a:buNone/>
              <a:defRPr sz="2806" b="1"/>
            </a:lvl1pPr>
            <a:lvl2pPr marL="534604" indent="0">
              <a:buNone/>
              <a:defRPr sz="2339" b="1"/>
            </a:lvl2pPr>
            <a:lvl3pPr marL="1069208" indent="0">
              <a:buNone/>
              <a:defRPr sz="2105" b="1"/>
            </a:lvl3pPr>
            <a:lvl4pPr marL="1603812" indent="0">
              <a:buNone/>
              <a:defRPr sz="1871" b="1"/>
            </a:lvl4pPr>
            <a:lvl5pPr marL="2138416" indent="0">
              <a:buNone/>
              <a:defRPr sz="1871" b="1"/>
            </a:lvl5pPr>
            <a:lvl6pPr marL="2673020" indent="0">
              <a:buNone/>
              <a:defRPr sz="1871" b="1"/>
            </a:lvl6pPr>
            <a:lvl7pPr marL="3207624" indent="0">
              <a:buNone/>
              <a:defRPr sz="1871" b="1"/>
            </a:lvl7pPr>
            <a:lvl8pPr marL="3742228" indent="0">
              <a:buNone/>
              <a:defRPr sz="1871" b="1"/>
            </a:lvl8pPr>
            <a:lvl9pPr marL="4276832" indent="0">
              <a:buNone/>
              <a:defRPr sz="187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6456" y="15780233"/>
            <a:ext cx="4523137" cy="2321034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12731" y="10590160"/>
            <a:ext cx="4545413" cy="5190073"/>
          </a:xfrm>
        </p:spPr>
        <p:txBody>
          <a:bodyPr anchor="b"/>
          <a:lstStyle>
            <a:lvl1pPr marL="0" indent="0">
              <a:buNone/>
              <a:defRPr sz="2806" b="1"/>
            </a:lvl1pPr>
            <a:lvl2pPr marL="534604" indent="0">
              <a:buNone/>
              <a:defRPr sz="2339" b="1"/>
            </a:lvl2pPr>
            <a:lvl3pPr marL="1069208" indent="0">
              <a:buNone/>
              <a:defRPr sz="2105" b="1"/>
            </a:lvl3pPr>
            <a:lvl4pPr marL="1603812" indent="0">
              <a:buNone/>
              <a:defRPr sz="1871" b="1"/>
            </a:lvl4pPr>
            <a:lvl5pPr marL="2138416" indent="0">
              <a:buNone/>
              <a:defRPr sz="1871" b="1"/>
            </a:lvl5pPr>
            <a:lvl6pPr marL="2673020" indent="0">
              <a:buNone/>
              <a:defRPr sz="1871" b="1"/>
            </a:lvl6pPr>
            <a:lvl7pPr marL="3207624" indent="0">
              <a:buNone/>
              <a:defRPr sz="1871" b="1"/>
            </a:lvl7pPr>
            <a:lvl8pPr marL="3742228" indent="0">
              <a:buNone/>
              <a:defRPr sz="1871" b="1"/>
            </a:lvl8pPr>
            <a:lvl9pPr marL="4276832" indent="0">
              <a:buNone/>
              <a:defRPr sz="187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12731" y="15780233"/>
            <a:ext cx="4545413" cy="2321034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9871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4814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1347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2880042"/>
            <a:ext cx="3448388" cy="10080149"/>
          </a:xfrm>
        </p:spPr>
        <p:txBody>
          <a:bodyPr anchor="b"/>
          <a:lstStyle>
            <a:lvl1pPr>
              <a:defRPr sz="374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45413" y="6220102"/>
            <a:ext cx="5412730" cy="30700453"/>
          </a:xfrm>
        </p:spPr>
        <p:txBody>
          <a:bodyPr/>
          <a:lstStyle>
            <a:lvl1pPr>
              <a:defRPr sz="3742"/>
            </a:lvl1pPr>
            <a:lvl2pPr>
              <a:defRPr sz="3274"/>
            </a:lvl2pPr>
            <a:lvl3pPr>
              <a:defRPr sz="2806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12960191"/>
            <a:ext cx="3448388" cy="24010358"/>
          </a:xfrm>
        </p:spPr>
        <p:txBody>
          <a:bodyPr/>
          <a:lstStyle>
            <a:lvl1pPr marL="0" indent="0">
              <a:buNone/>
              <a:defRPr sz="1871"/>
            </a:lvl1pPr>
            <a:lvl2pPr marL="534604" indent="0">
              <a:buNone/>
              <a:defRPr sz="1637"/>
            </a:lvl2pPr>
            <a:lvl3pPr marL="1069208" indent="0">
              <a:buNone/>
              <a:defRPr sz="1403"/>
            </a:lvl3pPr>
            <a:lvl4pPr marL="1603812" indent="0">
              <a:buNone/>
              <a:defRPr sz="1169"/>
            </a:lvl4pPr>
            <a:lvl5pPr marL="2138416" indent="0">
              <a:buNone/>
              <a:defRPr sz="1169"/>
            </a:lvl5pPr>
            <a:lvl6pPr marL="2673020" indent="0">
              <a:buNone/>
              <a:defRPr sz="1169"/>
            </a:lvl6pPr>
            <a:lvl7pPr marL="3207624" indent="0">
              <a:buNone/>
              <a:defRPr sz="1169"/>
            </a:lvl7pPr>
            <a:lvl8pPr marL="3742228" indent="0">
              <a:buNone/>
              <a:defRPr sz="1169"/>
            </a:lvl8pPr>
            <a:lvl9pPr marL="4276832" indent="0">
              <a:buNone/>
              <a:defRPr sz="116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6546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2880042"/>
            <a:ext cx="3448388" cy="10080149"/>
          </a:xfrm>
        </p:spPr>
        <p:txBody>
          <a:bodyPr anchor="b"/>
          <a:lstStyle>
            <a:lvl1pPr>
              <a:defRPr sz="374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45413" y="6220102"/>
            <a:ext cx="5412730" cy="30700453"/>
          </a:xfrm>
        </p:spPr>
        <p:txBody>
          <a:bodyPr anchor="t"/>
          <a:lstStyle>
            <a:lvl1pPr marL="0" indent="0">
              <a:buNone/>
              <a:defRPr sz="3742"/>
            </a:lvl1pPr>
            <a:lvl2pPr marL="534604" indent="0">
              <a:buNone/>
              <a:defRPr sz="3274"/>
            </a:lvl2pPr>
            <a:lvl3pPr marL="1069208" indent="0">
              <a:buNone/>
              <a:defRPr sz="2806"/>
            </a:lvl3pPr>
            <a:lvl4pPr marL="1603812" indent="0">
              <a:buNone/>
              <a:defRPr sz="2339"/>
            </a:lvl4pPr>
            <a:lvl5pPr marL="2138416" indent="0">
              <a:buNone/>
              <a:defRPr sz="2339"/>
            </a:lvl5pPr>
            <a:lvl6pPr marL="2673020" indent="0">
              <a:buNone/>
              <a:defRPr sz="2339"/>
            </a:lvl6pPr>
            <a:lvl7pPr marL="3207624" indent="0">
              <a:buNone/>
              <a:defRPr sz="2339"/>
            </a:lvl7pPr>
            <a:lvl8pPr marL="3742228" indent="0">
              <a:buNone/>
              <a:defRPr sz="2339"/>
            </a:lvl8pPr>
            <a:lvl9pPr marL="4276832" indent="0">
              <a:buNone/>
              <a:defRPr sz="2339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12960191"/>
            <a:ext cx="3448388" cy="24010358"/>
          </a:xfrm>
        </p:spPr>
        <p:txBody>
          <a:bodyPr/>
          <a:lstStyle>
            <a:lvl1pPr marL="0" indent="0">
              <a:buNone/>
              <a:defRPr sz="1871"/>
            </a:lvl1pPr>
            <a:lvl2pPr marL="534604" indent="0">
              <a:buNone/>
              <a:defRPr sz="1637"/>
            </a:lvl2pPr>
            <a:lvl3pPr marL="1069208" indent="0">
              <a:buNone/>
              <a:defRPr sz="1403"/>
            </a:lvl3pPr>
            <a:lvl4pPr marL="1603812" indent="0">
              <a:buNone/>
              <a:defRPr sz="1169"/>
            </a:lvl4pPr>
            <a:lvl5pPr marL="2138416" indent="0">
              <a:buNone/>
              <a:defRPr sz="1169"/>
            </a:lvl5pPr>
            <a:lvl6pPr marL="2673020" indent="0">
              <a:buNone/>
              <a:defRPr sz="1169"/>
            </a:lvl6pPr>
            <a:lvl7pPr marL="3207624" indent="0">
              <a:buNone/>
              <a:defRPr sz="1169"/>
            </a:lvl7pPr>
            <a:lvl8pPr marL="3742228" indent="0">
              <a:buNone/>
              <a:defRPr sz="1169"/>
            </a:lvl8pPr>
            <a:lvl9pPr marL="4276832" indent="0">
              <a:buNone/>
              <a:defRPr sz="116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802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5062" y="2300044"/>
            <a:ext cx="9221689" cy="8350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5062" y="11500170"/>
            <a:ext cx="9221689" cy="274104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5062" y="40040601"/>
            <a:ext cx="2405658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08039-61E9-EC4E-A6BF-AA985EF4695F}" type="datetimeFigureOut">
              <a:rPr lang="de-DE" smtClean="0"/>
              <a:t>21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41663" y="40040601"/>
            <a:ext cx="3608487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51093" y="40040601"/>
            <a:ext cx="2405658" cy="23000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44135-141B-4F4B-9950-EE730637FE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381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69208" rtl="0" eaLnBrk="1" latinLnBrk="0" hangingPunct="1">
        <a:lnSpc>
          <a:spcPct val="90000"/>
        </a:lnSpc>
        <a:spcBef>
          <a:spcPct val="0"/>
        </a:spcBef>
        <a:buNone/>
        <a:defRPr sz="51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7302" indent="-267302" algn="l" defTabSz="1069208" rtl="0" eaLnBrk="1" latinLnBrk="0" hangingPunct="1">
        <a:lnSpc>
          <a:spcPct val="90000"/>
        </a:lnSpc>
        <a:spcBef>
          <a:spcPts val="1169"/>
        </a:spcBef>
        <a:buFont typeface="Arial" panose="020B0604020202020204" pitchFamily="34" charset="0"/>
        <a:buChar char="•"/>
        <a:defRPr sz="3274" kern="1200">
          <a:solidFill>
            <a:schemeClr val="tx1"/>
          </a:solidFill>
          <a:latin typeface="+mn-lt"/>
          <a:ea typeface="+mn-ea"/>
          <a:cs typeface="+mn-cs"/>
        </a:defRPr>
      </a:lvl1pPr>
      <a:lvl2pPr marL="801906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2pPr>
      <a:lvl3pPr marL="1336510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3pPr>
      <a:lvl4pPr marL="1871114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405718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940322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4926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09530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4134" indent="-267302" algn="l" defTabSz="1069208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604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208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3812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8416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3020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7624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2228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6832" algn="l" defTabSz="1069208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>
            <a:extLst>
              <a:ext uri="{FF2B5EF4-FFF2-40B4-BE49-F238E27FC236}">
                <a16:creationId xmlns:a16="http://schemas.microsoft.com/office/drawing/2014/main" id="{FDCD21B6-1C14-8462-8AF0-159D6ADBC18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502831473"/>
              </p:ext>
            </p:extLst>
          </p:nvPr>
        </p:nvGraphicFramePr>
        <p:xfrm>
          <a:off x="0" y="0"/>
          <a:ext cx="6425567" cy="57828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64298">
                  <a:extLst>
                    <a:ext uri="{9D8B030D-6E8A-4147-A177-3AD203B41FA5}">
                      <a16:colId xmlns:a16="http://schemas.microsoft.com/office/drawing/2014/main" val="2979728590"/>
                    </a:ext>
                  </a:extLst>
                </a:gridCol>
                <a:gridCol w="650453">
                  <a:extLst>
                    <a:ext uri="{9D8B030D-6E8A-4147-A177-3AD203B41FA5}">
                      <a16:colId xmlns:a16="http://schemas.microsoft.com/office/drawing/2014/main" val="1264573708"/>
                    </a:ext>
                  </a:extLst>
                </a:gridCol>
                <a:gridCol w="4810816">
                  <a:extLst>
                    <a:ext uri="{9D8B030D-6E8A-4147-A177-3AD203B41FA5}">
                      <a16:colId xmlns:a16="http://schemas.microsoft.com/office/drawing/2014/main" val="3590068885"/>
                    </a:ext>
                  </a:extLst>
                </a:gridCol>
              </a:tblGrid>
              <a:tr h="321268">
                <a:tc gridSpan="3">
                  <a:txBody>
                    <a:bodyPr/>
                    <a:lstStyle/>
                    <a:p>
                      <a:pPr algn="l"/>
                      <a:r>
                        <a:rPr lang="en-GB" sz="1100" b="1" kern="1200" noProof="0" dirty="0">
                          <a:solidFill>
                            <a:srgbClr val="C23037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Supplementary Table ST1. </a:t>
                      </a:r>
                      <a:r>
                        <a:rPr lang="en-GB" sz="1100" b="1" noProof="0" dirty="0">
                          <a:solidFill>
                            <a:schemeClr val="tx1"/>
                          </a:solidFill>
                          <a:latin typeface="+mj-lt"/>
                          <a:cs typeface="Arial" panose="020B0604020202020204" pitchFamily="34" charset="0"/>
                        </a:rPr>
                        <a:t>Analyzed parameters</a:t>
                      </a:r>
                      <a:endParaRPr lang="en-GB" sz="1100" b="1" noProof="0" dirty="0">
                        <a:latin typeface="+mj-lt"/>
                        <a:cs typeface="Arial" panose="020B0604020202020204" pitchFamily="34" charset="0"/>
                      </a:endParaRPr>
                    </a:p>
                  </a:txBody>
                  <a:tcPr marL="51106" marR="5110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277" marR="58277" marT="0" marB="0">
                    <a:solidFill>
                      <a:srgbClr val="69AD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788733"/>
                  </a:ext>
                </a:extLst>
              </a:tr>
              <a:tr h="321268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GB" sz="1100" b="1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Demographic</a:t>
                      </a: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 Data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1106" marR="5110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0EBF2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Age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9571880"/>
                  </a:ext>
                </a:extLst>
              </a:tr>
              <a:tr h="321268">
                <a:tc gridSpan="2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Sex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5413715"/>
                  </a:ext>
                </a:extLst>
              </a:tr>
              <a:tr h="321268">
                <a:tc rowSpan="15">
                  <a:txBody>
                    <a:bodyPr/>
                    <a:lstStyle/>
                    <a:p>
                      <a:pPr algn="ctr"/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Clinical and laboratory data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1106" marR="5110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rowSpan="7">
                  <a:txBody>
                    <a:bodyPr/>
                    <a:lstStyle/>
                    <a:p>
                      <a:pPr algn="ctr"/>
                      <a:r>
                        <a:rPr lang="en-GB" sz="1100" b="1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Pre-RC</a:t>
                      </a:r>
                      <a:endParaRPr lang="en-GB" sz="1100" b="1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1106" marR="51106" marT="0" marB="0" anchor="ctr"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Time and day of presentation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386302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Mode of arrival and referral pathway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4153857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Presenting complaints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7279516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Rheumatological past medical history and medication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3450314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Pain severity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8946577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de-DE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277" marR="58277" marT="0" marB="0" anchor="ctr"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Manchester Triage System</a:t>
                      </a: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592475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de-DE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277" marR="58277" marT="0" marB="0" anchor="ctr"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C-reactive protein (CRP)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2243301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5">
                  <a:txBody>
                    <a:bodyPr/>
                    <a:lstStyle/>
                    <a:p>
                      <a:pPr algn="ctr"/>
                      <a:r>
                        <a:rPr lang="en-GB" sz="1100" b="1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RC</a:t>
                      </a:r>
                    </a:p>
                  </a:txBody>
                  <a:tcPr marL="80189" marR="80189" marT="40094" marB="40094" anchor="ctr"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Urgency of RC and time until RC requested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9242319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Reason for RC request 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6215224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Recommended diagnostic tests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1616834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Recommended treatment plan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8467930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RC diagnosis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3068561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/>
                      <a:endParaRPr lang="en-GB" sz="1100" b="1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100" b="1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Post-RC</a:t>
                      </a:r>
                      <a:endParaRPr lang="en-GB" sz="1100" b="1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1106" marR="51106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cs typeface="Arial" panose="020B0604020202020204" pitchFamily="34" charset="0"/>
                        </a:rPr>
                        <a:t>Treatment pathway after ED</a:t>
                      </a:r>
                      <a:endParaRPr lang="en-GB" sz="1100" kern="100" noProof="0" dirty="0">
                        <a:solidFill>
                          <a:schemeClr val="tx1"/>
                        </a:solidFill>
                        <a:effectLst/>
                        <a:latin typeface="+mj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8264307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Diagnosis at discharge</a:t>
                      </a: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370744"/>
                  </a:ext>
                </a:extLst>
              </a:tr>
              <a:tr h="321268">
                <a:tc vMerge="1">
                  <a:txBody>
                    <a:bodyPr/>
                    <a:lstStyle/>
                    <a:p>
                      <a:pPr algn="ctr"/>
                      <a:endParaRPr lang="de-DE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277" marR="5827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de-DE" sz="1200" b="1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58277" marR="58277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00" noProof="0" dirty="0">
                          <a:solidFill>
                            <a:schemeClr val="tx1"/>
                          </a:solidFill>
                          <a:effectLst/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Discharge medication</a:t>
                      </a:r>
                    </a:p>
                  </a:txBody>
                  <a:tcPr marL="80189" marR="80189" marT="40094" marB="40094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6381139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F3609B8A-65D6-5B73-8BE1-9F3476A50836}"/>
              </a:ext>
            </a:extLst>
          </p:cNvPr>
          <p:cNvSpPr txBox="1"/>
          <p:nvPr/>
        </p:nvSpPr>
        <p:spPr>
          <a:xfrm>
            <a:off x="6425567" y="0"/>
            <a:ext cx="3916844" cy="2240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579" u="sng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Supplementary Table ST1. Analyzed Parameters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Overview of all parameters that were analyzed. Before rheumatological consultation (Pre-RC), after rheumatological consultation (Post-RC), emergency department (ED).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575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11">
            <a:extLst>
              <a:ext uri="{FF2B5EF4-FFF2-40B4-BE49-F238E27FC236}">
                <a16:creationId xmlns:a16="http://schemas.microsoft.com/office/drawing/2014/main" id="{18A0E4EA-398D-37ED-F6DC-8FB6FEEF2A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4462881"/>
              </p:ext>
            </p:extLst>
          </p:nvPr>
        </p:nvGraphicFramePr>
        <p:xfrm>
          <a:off x="0" y="0"/>
          <a:ext cx="8870585" cy="52173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21258">
                  <a:extLst>
                    <a:ext uri="{9D8B030D-6E8A-4147-A177-3AD203B41FA5}">
                      <a16:colId xmlns:a16="http://schemas.microsoft.com/office/drawing/2014/main" val="272009250"/>
                    </a:ext>
                  </a:extLst>
                </a:gridCol>
                <a:gridCol w="2383109">
                  <a:extLst>
                    <a:ext uri="{9D8B030D-6E8A-4147-A177-3AD203B41FA5}">
                      <a16:colId xmlns:a16="http://schemas.microsoft.com/office/drawing/2014/main" val="2627782699"/>
                    </a:ext>
                  </a:extLst>
                </a:gridCol>
                <a:gridCol w="2383109">
                  <a:extLst>
                    <a:ext uri="{9D8B030D-6E8A-4147-A177-3AD203B41FA5}">
                      <a16:colId xmlns:a16="http://schemas.microsoft.com/office/drawing/2014/main" val="3409608464"/>
                    </a:ext>
                  </a:extLst>
                </a:gridCol>
                <a:gridCol w="2383109">
                  <a:extLst>
                    <a:ext uri="{9D8B030D-6E8A-4147-A177-3AD203B41FA5}">
                      <a16:colId xmlns:a16="http://schemas.microsoft.com/office/drawing/2014/main" val="3805868713"/>
                    </a:ext>
                  </a:extLst>
                </a:gridCol>
              </a:tblGrid>
              <a:tr h="442942">
                <a:tc gridSpan="4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noProof="0" dirty="0">
                          <a:ln>
                            <a:noFill/>
                          </a:ln>
                          <a:solidFill>
                            <a:srgbClr val="C23037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Supplementary Table ST2.</a:t>
                      </a:r>
                      <a:r>
                        <a:rPr lang="en-GB" sz="1000" b="1" kern="12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 List of symptoms </a:t>
                      </a:r>
                    </a:p>
                  </a:txBody>
                  <a:tcPr marL="80189" marR="80189" marT="40094" marB="4009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050" b="1" kern="12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050" b="1" kern="12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050" b="1" kern="120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7542383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rthritis/Arthralgi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Unspecific symptoms suggesting infec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Hearing los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hronic woun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5748502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olyarthritis</a:t>
                      </a:r>
                      <a:r>
                        <a:rPr lang="en-GB" sz="900" b="0" i="0" u="none" strike="noStrike" noProof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/Polyarthralgia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Headache/ jaw claudic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Epistaxi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ash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7556114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Oligoarthriti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araesthesi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Dysphagi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Oral ulcer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8490526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onoarthriti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Gait abnormalitie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Dysphonia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Alopeci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726315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wollen joint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uscle cramp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ough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ausea and vomiting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5420233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orning stiffnes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Dizzines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Haemoptysi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Diarrhoea/constipation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9816127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yalgia and unspecific MSK Symptom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Delirium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Chest pai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Gastrointestinal pai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0140819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Muscle weaknes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anic attack 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Palpitations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Urogenital symptom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6385658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Back/Neck pai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Low moo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Dyspnoe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Oedem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7573186"/>
                  </a:ext>
                </a:extLst>
              </a:tr>
              <a:tr h="36609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Decreased general condi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Diplopi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eripheral cyanosi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Generalized pai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4178162"/>
                  </a:ext>
                </a:extLst>
              </a:tr>
              <a:tr h="393434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Weight loss and night sweat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Uveitis/</a:t>
                      </a: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cleritis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yncope</a:t>
                      </a: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Bleeding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8784811"/>
                  </a:ext>
                </a:extLst>
              </a:tr>
              <a:tr h="360002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ever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Loss of vis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aynau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6909804"/>
                  </a:ext>
                </a:extLst>
              </a:tr>
              <a:tr h="360002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wellings and lump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Sicca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noProof="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Skin necrosis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kern="1200" noProof="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2622294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CB0136A8-CA90-B53E-C1FB-EFECB85B4993}"/>
              </a:ext>
            </a:extLst>
          </p:cNvPr>
          <p:cNvSpPr txBox="1"/>
          <p:nvPr/>
        </p:nvSpPr>
        <p:spPr>
          <a:xfrm>
            <a:off x="0" y="5217330"/>
            <a:ext cx="9686273" cy="782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579" u="sng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Supplementary Table ST2. List of symptoms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Overview of all documented symptoms of patients presenting to the emergency department.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6763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DB0A21-180B-D3D9-BBB8-8F930CFCEE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BE778A08-D0ED-D9B9-D99A-0324FE6295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7364269"/>
              </p:ext>
            </p:extLst>
          </p:nvPr>
        </p:nvGraphicFramePr>
        <p:xfrm>
          <a:off x="0" y="0"/>
          <a:ext cx="5311765" cy="355135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55757">
                  <a:extLst>
                    <a:ext uri="{9D8B030D-6E8A-4147-A177-3AD203B41FA5}">
                      <a16:colId xmlns:a16="http://schemas.microsoft.com/office/drawing/2014/main" val="3167344867"/>
                    </a:ext>
                  </a:extLst>
                </a:gridCol>
                <a:gridCol w="2362839">
                  <a:extLst>
                    <a:ext uri="{9D8B030D-6E8A-4147-A177-3AD203B41FA5}">
                      <a16:colId xmlns:a16="http://schemas.microsoft.com/office/drawing/2014/main" val="3894780485"/>
                    </a:ext>
                  </a:extLst>
                </a:gridCol>
                <a:gridCol w="490362">
                  <a:extLst>
                    <a:ext uri="{9D8B030D-6E8A-4147-A177-3AD203B41FA5}">
                      <a16:colId xmlns:a16="http://schemas.microsoft.com/office/drawing/2014/main" val="1252870245"/>
                    </a:ext>
                  </a:extLst>
                </a:gridCol>
                <a:gridCol w="646257">
                  <a:extLst>
                    <a:ext uri="{9D8B030D-6E8A-4147-A177-3AD203B41FA5}">
                      <a16:colId xmlns:a16="http://schemas.microsoft.com/office/drawing/2014/main" val="217476261"/>
                    </a:ext>
                  </a:extLst>
                </a:gridCol>
                <a:gridCol w="856550">
                  <a:extLst>
                    <a:ext uri="{9D8B030D-6E8A-4147-A177-3AD203B41FA5}">
                      <a16:colId xmlns:a16="http://schemas.microsoft.com/office/drawing/2014/main" val="3825774306"/>
                    </a:ext>
                  </a:extLst>
                </a:gridCol>
              </a:tblGrid>
              <a:tr h="294025">
                <a:tc gridSpan="5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kern="1200" noProof="0" dirty="0">
                          <a:ln>
                            <a:noFill/>
                          </a:ln>
                          <a:solidFill>
                            <a:srgbClr val="C23037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Supplementary Table ST3.</a:t>
                      </a:r>
                      <a:r>
                        <a:rPr lang="en-GB" sz="700" b="1" kern="12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 Logistic regression model without RC</a:t>
                      </a:r>
                      <a:endParaRPr lang="en-GB" sz="700" b="0" i="0" u="none" strike="noStrike" kern="120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700" b="1" kern="120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latin typeface="+mj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0094" marR="40094" marT="40094" marB="4009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6656044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ependent variabl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iagnosis IRD at discharge [yes, no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40740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egression typ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Logistic regression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2238"/>
                  </a:ext>
                </a:extLst>
              </a:tr>
              <a:tr h="187107">
                <a:tc gridSpan="5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923790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Model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620185"/>
                  </a:ext>
                </a:extLst>
              </a:tr>
              <a:tr h="22218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arameter estimate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Estimat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ctr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Standard error</a:t>
                      </a:r>
                    </a:p>
                  </a:txBody>
                  <a:tcPr marL="0" marR="0" marT="0" marB="0" anchor="ctr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95% CI (profile likelihood)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275464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0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9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2,604 to 0,5216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155187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986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80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005760 to 0,0257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850677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46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6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3952 to 0,6906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846660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86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5764 to 0,9424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258461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14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88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9126 to 0,6150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938756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048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064 to 0,9696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942011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1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362 to 1,91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5481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1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5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072 to 1,112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664329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61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942 to 0,698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668033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7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9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6731 to 0,781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64456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1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3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2,689 to 0,2419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93952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 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0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4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074 to 1,466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745209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7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14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7508 to 1,683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777241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6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8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3842 to 2,30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36229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2468 to 0,9656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438113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1356 to 1,287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50513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13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19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002411 to 0,005092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35420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6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3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4879 to 0,8164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396384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22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6663 to 0,6720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701199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25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294 to 0,754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048031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24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6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360 to 0,8583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291668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,9482 to 2,65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251000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3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1,048 to 3,153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96996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,5584 to 3,450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71796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8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1622 to 4,662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790897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(Symptom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010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6764 to 0,6615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034245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81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615 to -0,0336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359049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49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203 to 0,2024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232222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8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0,0008233 to 1,45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90053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02348 to 1,559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84458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061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7665 to 0,652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488205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5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49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2,428 to -0,6541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97491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62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6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1,564 to 0,2888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84051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6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-0,4904 to 1,360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858010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688777"/>
                  </a:ext>
                </a:extLst>
              </a:tr>
              <a:tr h="21383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Odds ratio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Estimat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95% CI (profile likelihood)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b="1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07419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7400 to 1,6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15162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43 to 1,0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60778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5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736 to 1,99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940296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619 to 2,56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2550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6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15 to 1,85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100662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5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49 to 2,6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54785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560 to 6,7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58430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24 to 3,0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638988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434 to 2,0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169641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01 to 2,1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948316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6795 to 1,2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099776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 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15 to 4,3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359378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720 to 5,38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630448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6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810 to 10,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558508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813 to 2,6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34504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7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732 to 3,6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52061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76 to 1,0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4676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139 to 2,26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78081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36 to 1,95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50406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7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43 to 2,1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76504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8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567 to 2,35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13868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8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581 to 14,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21098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7,5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852 to 23,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522773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748 to 31,4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46590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503 to 105,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054863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(Symptom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8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84 to 1,9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287486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988 to 0,96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12360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08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04 to 1,2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84757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01 to 4,26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389496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1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768 to 4,7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100013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4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646 to 1,9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58637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882 to 0,51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188045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094 to 1,3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769150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124 to 3,89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319911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857159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Sig. diff. than zero?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|Z|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 valu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P value summary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551027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9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99831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1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05304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2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9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738033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7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36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48595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7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1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248280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93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2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539580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2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830515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38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7287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2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4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4581708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9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528770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26350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 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5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13986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7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9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128856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808072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347356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995670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8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9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217689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8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2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852905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65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3503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9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1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70022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5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6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432300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,07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&lt;0,0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****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41991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8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***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76849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57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1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899945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3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817010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(Symptoms)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31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74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402089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54988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6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505061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9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5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859889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8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6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98986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6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6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481724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3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***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40833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35304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84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76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ns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312434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857572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l diagnostic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egrees of Freedom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AICc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190857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-only mode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53,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363123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lected mode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30,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58822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0183499"/>
                  </a:ext>
                </a:extLst>
              </a:tr>
              <a:tr h="21383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Multicollinearity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IF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R2 with other variable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b="1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93401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270932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6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6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055627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endParaRPr lang="en-GB" sz="700" u="none" strike="noStrike" kern="1200" noProof="0" dirty="0">
                        <a:solidFill>
                          <a:schemeClr val="dk1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420919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288738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031728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79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379106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983536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9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94425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36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882773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93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923903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549290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 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8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28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435938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3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91933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2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281956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791856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7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243611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8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970231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2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423371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5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443029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86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23393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4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18671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780709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9435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4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41697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89614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(Symptom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4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099836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682209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9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99064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91931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646562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5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320181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3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688743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20263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99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6528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2000351"/>
                  </a:ext>
                </a:extLst>
              </a:tr>
              <a:tr h="187107">
                <a:tc gridSpan="5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Area under the ROC curv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de-DE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19721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rea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0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15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td. Error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3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0769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5% confidence interva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537 to 0,84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51126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 valu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&lt;0,0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95853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0653979"/>
                  </a:ext>
                </a:extLst>
              </a:tr>
              <a:tr h="22218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Classification t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redicted 0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redicted 1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Total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% Correctly </a:t>
                      </a:r>
                      <a:b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</a:b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classified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928745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bserved 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7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58,14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132760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bserved 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7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82,94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445034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ota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buNone/>
                      </a:pPr>
                      <a:r>
                        <a:rPr lang="en-GB" sz="700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73,53</a:t>
                      </a: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971734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3058139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egative predictive power (%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7,5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695725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sitive predictive power (%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76,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97227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653422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lassification cutoff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82782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128653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2358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ata summary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268426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in tabl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4540112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skipped (missing data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5302533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analyzed (#observations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609995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909296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4653779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parameter estimate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7050032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observations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3960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1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69337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0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1087674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parameter estimate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4860515"/>
                  </a:ext>
                </a:extLst>
              </a:tr>
              <a:tr h="294025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observations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,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824526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1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102874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0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endParaRPr lang="en-GB" sz="900" b="0" i="0" u="none" strike="noStrike" noProof="0" dirty="0">
                        <a:effectLst/>
                        <a:latin typeface="+mj-lt"/>
                      </a:endParaRPr>
                    </a:p>
                  </a:txBody>
                  <a:tcPr marL="8353" marR="8353" marT="8353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0265238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C1ACDEF0-9784-BEC1-8D2A-08A581158FAB}"/>
              </a:ext>
            </a:extLst>
          </p:cNvPr>
          <p:cNvSpPr txBox="1"/>
          <p:nvPr/>
        </p:nvSpPr>
        <p:spPr>
          <a:xfrm>
            <a:off x="5311765" y="0"/>
            <a:ext cx="5345906" cy="18760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579" u="sng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Supplementary Table ST3. Logistic regression model without rheumatological consultation (RC)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Detailed outcome of our logistic regression model for predicting an inflammatory rheumatic disease (IRD) diagnosis at discharge without RC. </a:t>
            </a:r>
            <a:r>
              <a:rPr lang="en-US" sz="1579" dirty="0">
                <a:latin typeface="Calibri Light" panose="020F0302020204030204" pitchFamily="34" charset="0"/>
                <a:ea typeface="Times New Roman" panose="02020603050405020304" pitchFamily="18" charset="0"/>
              </a:rPr>
              <a:t>*** p&lt;0.001, ** p</a:t>
            </a: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&lt;0.01, * p&lt;0.05.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82885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EACBAB-FFEF-D2AC-FE86-377383F8661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elle 8">
            <a:extLst>
              <a:ext uri="{FF2B5EF4-FFF2-40B4-BE49-F238E27FC236}">
                <a16:creationId xmlns:a16="http://schemas.microsoft.com/office/drawing/2014/main" id="{EED4D1AB-FCD1-9C20-8A54-FEC003FE57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5445545"/>
              </p:ext>
            </p:extLst>
          </p:nvPr>
        </p:nvGraphicFramePr>
        <p:xfrm>
          <a:off x="0" y="0"/>
          <a:ext cx="7186484" cy="3669266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98846">
                  <a:extLst>
                    <a:ext uri="{9D8B030D-6E8A-4147-A177-3AD203B41FA5}">
                      <a16:colId xmlns:a16="http://schemas.microsoft.com/office/drawing/2014/main" val="1245328843"/>
                    </a:ext>
                  </a:extLst>
                </a:gridCol>
                <a:gridCol w="3280686">
                  <a:extLst>
                    <a:ext uri="{9D8B030D-6E8A-4147-A177-3AD203B41FA5}">
                      <a16:colId xmlns:a16="http://schemas.microsoft.com/office/drawing/2014/main" val="1386244729"/>
                    </a:ext>
                  </a:extLst>
                </a:gridCol>
                <a:gridCol w="835298">
                  <a:extLst>
                    <a:ext uri="{9D8B030D-6E8A-4147-A177-3AD203B41FA5}">
                      <a16:colId xmlns:a16="http://schemas.microsoft.com/office/drawing/2014/main" val="531675719"/>
                    </a:ext>
                  </a:extLst>
                </a:gridCol>
                <a:gridCol w="710003">
                  <a:extLst>
                    <a:ext uri="{9D8B030D-6E8A-4147-A177-3AD203B41FA5}">
                      <a16:colId xmlns:a16="http://schemas.microsoft.com/office/drawing/2014/main" val="3757107289"/>
                    </a:ext>
                  </a:extLst>
                </a:gridCol>
                <a:gridCol w="95465">
                  <a:extLst>
                    <a:ext uri="{9D8B030D-6E8A-4147-A177-3AD203B41FA5}">
                      <a16:colId xmlns:a16="http://schemas.microsoft.com/office/drawing/2014/main" val="2367467036"/>
                    </a:ext>
                  </a:extLst>
                </a:gridCol>
                <a:gridCol w="666186">
                  <a:extLst>
                    <a:ext uri="{9D8B030D-6E8A-4147-A177-3AD203B41FA5}">
                      <a16:colId xmlns:a16="http://schemas.microsoft.com/office/drawing/2014/main" val="2511530156"/>
                    </a:ext>
                  </a:extLst>
                </a:gridCol>
              </a:tblGrid>
              <a:tr h="294025">
                <a:tc gridSpan="6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kern="1200" noProof="0" dirty="0">
                          <a:ln>
                            <a:noFill/>
                          </a:ln>
                          <a:solidFill>
                            <a:srgbClr val="C23037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Supplementary Table ST4.</a:t>
                      </a:r>
                      <a:r>
                        <a:rPr lang="en-GB" sz="700" b="1" kern="120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Arial" panose="020B0604020202020204" pitchFamily="34" charset="0"/>
                        </a:rPr>
                        <a:t> Logistic regression model with RC</a:t>
                      </a:r>
                    </a:p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205778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ependent variabl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iagnosis IRD at discharge [yes, no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22418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egression typ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Logistic regression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472640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787481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Model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6685229"/>
                  </a:ext>
                </a:extLst>
              </a:tr>
              <a:tr h="21383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arameter estimate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Estimat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Standard error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>
                          <a:effectLst/>
                          <a:latin typeface="+mj-lt"/>
                        </a:rPr>
                        <a:t>95% CI (profile likelihood)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b="1" u="none" strike="noStrike" noProof="0" dirty="0">
                          <a:effectLst/>
                          <a:latin typeface="+mj-lt"/>
                        </a:rPr>
                        <a:t>95% CI (profile likelihood)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8161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3,1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5,418 to -1,0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5,418 to -1,021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4246263"/>
                  </a:ext>
                </a:extLst>
              </a:tr>
              <a:tr h="206804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0000676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10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02052 to 0,020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02052 to 0,02051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37516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 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5878 to 0,81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5878 to 0,8188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662096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0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7844 to 1,1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7844 to 1,188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812476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1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99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124 to 0,84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124 to 0,8436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357811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22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34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471 to 1,0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471 to 1,030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594318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556 to 2,5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556 to 2,596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306892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5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7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305 to 1,3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305 to 1,37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2554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22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26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853 to 1,4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853 to 1,408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08553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17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4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8268 to 0,93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8268 to 0,9388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051603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4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3,625 to 0,85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3,625 to 0,8533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67188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 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94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1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533 to 1,6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533 to 1,676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238845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5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504 to 1,5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504 to 1,503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856989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7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027 to 2,4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027 to 2,418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140137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6546 to 0,925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6546 to 0,9250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04299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8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2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1013 to 1,95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1013 to 1,959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708027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23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254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00262 to 0,007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002622 to 0,007409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107166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325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196 to 0,53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196 to 0,5313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9689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30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202 to 0,578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202 to 0,578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143782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60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3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890 to 0,616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890 to 0,616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317265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47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885 to 0,888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885 to 0,8880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97796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77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0,3450 to 2,6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0,3450 to 2,624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479688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0,4905 to 2,9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0,4905 to 2,97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598730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8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4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0,1628 to 3,8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0,1628 to 3,89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15151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8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338 to 3,6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338 to 3,606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693646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43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305 to 0,426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305 to 0,4267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754831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16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2,184 to -0,17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2,184 to -0,1730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17305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67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6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9007 to 0,92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9007 to 0,9284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986002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3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74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0,02647 to 1,89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0,02647 to 1,895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96051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5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5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02845 to 2,00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02845 to 2,005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726877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78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6080 to 1,2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6080 to 1,274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620175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1,69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2,820 to -0,63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2,820 to -0,6343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656649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-0,61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05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806 to 0,58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806 to 0,5817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934322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0,4479 to 1,8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0,4479 to 1,891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19414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6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-1,199 to 3,8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-1,199 to 3,825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46011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further tests needed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4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7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1,185 to 3,87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1,185 to 3,879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77427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,8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95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3,604 to 6,37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3,604 to 6,372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519035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40037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0515997"/>
                  </a:ext>
                </a:extLst>
              </a:tr>
              <a:tr h="21383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Odds ratio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Estimat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95% CI (profile likelihood)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35910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3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4438 to 0,36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059734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797 to 1,0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194860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 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555 to 2,26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640377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564 to 3,28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397732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7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248 to 2,3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174876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99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98 to 2,8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354332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110 to 13,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767425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13 to 3,9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0885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9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67 to 4,08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252159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4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374 to 2,55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154349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5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665 to 2,3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40722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160 to 5,3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34902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22 to 4,49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35815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81 to 11,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61881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196 to 2,5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164994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4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036 to 7,09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539120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74 to 1,0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291475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2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23 to 1,7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087172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05 to 1,7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243346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4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10 to 1,8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667070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19 to 2,4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342502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,1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412 to 13,8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55057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2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33 to 19,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54302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37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77 to 49,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235376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7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623 to 36,8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24552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45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12 to 1,5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544244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26 to 0,84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56634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0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63 to 2,5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068771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54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27 to 6,6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17791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5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719 to 7,4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231082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444 to 3,5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615667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8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5962 to 0,53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323814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4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642 to 1,7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03747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99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390 to 6,6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44989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9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014 to 45,8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675498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further tests needed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1,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271 to 48,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85362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26,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6,74 to 585,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661091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882302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692540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Sig. diff. than zero?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|Z|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 valu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>
                          <a:effectLst/>
                          <a:latin typeface="+mj-lt"/>
                        </a:rPr>
                        <a:t>P value summary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b="1" u="none" strike="noStrike" noProof="0" dirty="0">
                          <a:effectLst/>
                          <a:latin typeface="+mj-lt"/>
                        </a:rPr>
                        <a:t>P value summary</a:t>
                      </a: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77312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8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5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622305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64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9267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 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7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50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3639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00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86754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64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9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75316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5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2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53886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89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9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140529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38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6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9155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8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45789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93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25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314894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9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630172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6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0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40392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329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7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559848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1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15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63487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2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319391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8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83673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0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5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69478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45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273590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66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461476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5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37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672572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7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05159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47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1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650073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63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782941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9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8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205214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1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834046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9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085389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2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2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52522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1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8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81696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9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4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455248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8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6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014736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667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4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373720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06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382993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1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933013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6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4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26454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0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n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ns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260151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further tests needed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55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00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*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*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693870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95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&lt;0,0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>
                          <a:effectLst/>
                          <a:latin typeface="+mj-lt"/>
                        </a:rPr>
                        <a:t>****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800" u="none" strike="noStrike" noProof="0" dirty="0">
                          <a:effectLst/>
                          <a:latin typeface="+mj-lt"/>
                        </a:rPr>
                        <a:t>****</a:t>
                      </a: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161018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047375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l diagnostic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egrees of Freedom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AICc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55667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-only mode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453,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32405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lected mode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23,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980637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749173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45040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Multicollinearity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ari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VIF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R2 with other variables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6824709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Intercept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77540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ge [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8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7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50948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ex [m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6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435120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non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5064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GP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0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0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932467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another special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6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8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7923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edical contact prior to ED [rheumatologis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8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712010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walk-in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98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577916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de of Arrival [ambulance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4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76717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400939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ut of hours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6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38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723852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less/non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85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2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560209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6,0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35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939893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riage [immediate/very urgent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25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0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914078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killer or NSAI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1437171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rednisol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7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72155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RP [mg/dl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8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2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092443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week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4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218627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ymptom Duration [months to year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57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36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01379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low= 0-5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89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4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24622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ain (triage) [high=6-10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4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70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216061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ny arthritis/arthralgia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3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38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819754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lyarthritis/</a:t>
                      </a:r>
                      <a:r>
                        <a:rPr lang="en-GB" sz="700" u="none" strike="noStrike" noProof="0" dirty="0" err="1">
                          <a:effectLst/>
                          <a:latin typeface="+mj-lt"/>
                        </a:rPr>
                        <a:t>polyarthralgias</a:t>
                      </a: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90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901579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wollen jo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00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791949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orning stiffnes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415833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Myalgia and unspecific MSK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8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58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304352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Generalized pai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781511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ever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8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1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765397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Weight loss and night swea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60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345488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kin condition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16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23814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fatigue and decreased general condition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37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556594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yspnoea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6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42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38018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bdominal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4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27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45981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ENT complaints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1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10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08553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unclear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,2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2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601627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further tests needed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134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3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21910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β3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C diagnosis IRD [yes]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,37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7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841077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72126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rea under the ROC curv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854365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Area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919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837105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Std. Error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0151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281571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5% confidence interva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8899 to 0,94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6027042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 valu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&lt;0,000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20196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69868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0238451"/>
                  </a:ext>
                </a:extLst>
              </a:tr>
              <a:tr h="21383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Classification table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redicted 0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Predicted 1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b="1" u="none" strike="noStrike" noProof="0" dirty="0">
                          <a:effectLst/>
                          <a:latin typeface="+mj-lt"/>
                        </a:rPr>
                        <a:t>Total</a:t>
                      </a:r>
                      <a:endParaRPr lang="en-GB" sz="7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1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u="none" strike="noStrike" kern="1200" noProof="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% Correctly classified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9084984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bserved 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6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74,4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193689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Observed 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9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1380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Total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1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2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84,7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3475416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658029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egative predictive power (%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83,48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430236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Positive predictive power (%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85,33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0322913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098837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Classification cutoff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,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574654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412956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Data summary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136975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in table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892271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skipped (missing data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346493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Rows analyzed (#observations)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4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87883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211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8917139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0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129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4082858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Number of parameter estimate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868170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observations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9,2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133255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1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5,7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B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2045717"/>
                  </a:ext>
                </a:extLst>
              </a:tr>
              <a:tr h="18710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# of 0/#parameters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40094" marR="40094" marT="40094" marB="40094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en-GB" sz="700" u="none" strike="noStrike" noProof="0" dirty="0">
                          <a:effectLst/>
                          <a:latin typeface="+mj-lt"/>
                        </a:rPr>
                        <a:t>3,5</a:t>
                      </a: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700" b="0" i="0" u="none" strike="noStrike" noProof="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EB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244873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C3AB88C6-822B-60B1-32C2-242EFBB7CFB1}"/>
              </a:ext>
            </a:extLst>
          </p:cNvPr>
          <p:cNvSpPr txBox="1"/>
          <p:nvPr/>
        </p:nvSpPr>
        <p:spPr>
          <a:xfrm>
            <a:off x="7186484" y="0"/>
            <a:ext cx="3505329" cy="29695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579" u="sng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Supplementary Table ST4. Logistic regression model with rheumatological consultation (RC)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Detailed outcome of our logistic regression model for predicting an inflammatory rheumatic disease (IRD) diagnosis at discharge including RC. </a:t>
            </a:r>
            <a:r>
              <a:rPr lang="en-US" sz="1579" dirty="0">
                <a:latin typeface="Calibri Light" panose="020F0302020204030204" pitchFamily="34" charset="0"/>
                <a:ea typeface="Times New Roman" panose="02020603050405020304" pitchFamily="18" charset="0"/>
              </a:rPr>
              <a:t>*** p&lt;0.001, ** p</a:t>
            </a:r>
            <a:r>
              <a:rPr lang="en-US" sz="1579" dirty="0">
                <a:solidFill>
                  <a:srgbClr val="000000"/>
                </a:solidFill>
                <a:latin typeface="Calibri Light" panose="020F0302020204030204" pitchFamily="34" charset="0"/>
                <a:ea typeface="Times New Roman" panose="02020603050405020304" pitchFamily="18" charset="0"/>
              </a:rPr>
              <a:t>&lt;0.01, * p&lt;0.05.</a:t>
            </a:r>
            <a:endParaRPr lang="de-DE" sz="1754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3907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99C0761-8A3B-E132-136E-35FFF1CCCA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96BF55C2-32CF-DD70-E765-468062CDE4E9}"/>
              </a:ext>
            </a:extLst>
          </p:cNvPr>
          <p:cNvSpPr txBox="1"/>
          <p:nvPr/>
        </p:nvSpPr>
        <p:spPr>
          <a:xfrm>
            <a:off x="0" y="85025"/>
            <a:ext cx="5956867" cy="3353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801978">
              <a:defRPr/>
            </a:pPr>
            <a:r>
              <a:rPr lang="en-GB" sz="1579" b="1" dirty="0">
                <a:solidFill>
                  <a:srgbClr val="C2303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F1.</a:t>
            </a:r>
            <a:r>
              <a:rPr lang="en-GB" sz="1579" b="1" dirty="0">
                <a:latin typeface="Arial" panose="020B0604020202020204" pitchFamily="34" charset="0"/>
                <a:cs typeface="Arial" panose="020B0604020202020204" pitchFamily="34" charset="0"/>
              </a:rPr>
              <a:t> Neural network without RC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FDA0B653-AC83-4C51-B83E-375410C4551F}"/>
              </a:ext>
            </a:extLst>
          </p:cNvPr>
          <p:cNvSpPr txBox="1"/>
          <p:nvPr/>
        </p:nvSpPr>
        <p:spPr>
          <a:xfrm>
            <a:off x="129912" y="5643353"/>
            <a:ext cx="1034257" cy="281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28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 Layer</a:t>
            </a:r>
            <a:endParaRPr lang="en-GB" sz="122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5185E552-BEE2-4AE0-9281-5AB191A50F55}"/>
              </a:ext>
            </a:extLst>
          </p:cNvPr>
          <p:cNvSpPr txBox="1"/>
          <p:nvPr/>
        </p:nvSpPr>
        <p:spPr>
          <a:xfrm>
            <a:off x="2419772" y="5643353"/>
            <a:ext cx="1183337" cy="281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28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dden Layer</a:t>
            </a:r>
            <a:endParaRPr lang="en-GB" sz="122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>
            <a:extLst>
              <a:ext uri="{FF2B5EF4-FFF2-40B4-BE49-F238E27FC236}">
                <a16:creationId xmlns:a16="http://schemas.microsoft.com/office/drawing/2014/main" id="{FEB6208E-763D-4AD3-B176-2B7B6348A0C0}"/>
              </a:ext>
            </a:extLst>
          </p:cNvPr>
          <p:cNvCxnSpPr/>
          <p:nvPr/>
        </p:nvCxnSpPr>
        <p:spPr>
          <a:xfrm>
            <a:off x="142880" y="77501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>
            <a:extLst>
              <a:ext uri="{FF2B5EF4-FFF2-40B4-BE49-F238E27FC236}">
                <a16:creationId xmlns:a16="http://schemas.microsoft.com/office/drawing/2014/main" id="{E545250E-3443-46FC-A31D-A38FE58E2673}"/>
              </a:ext>
            </a:extLst>
          </p:cNvPr>
          <p:cNvCxnSpPr/>
          <p:nvPr/>
        </p:nvCxnSpPr>
        <p:spPr>
          <a:xfrm>
            <a:off x="142880" y="911772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id="{733C6F74-0AE2-4546-A82C-DD4846943219}"/>
              </a:ext>
            </a:extLst>
          </p:cNvPr>
          <p:cNvCxnSpPr/>
          <p:nvPr/>
        </p:nvCxnSpPr>
        <p:spPr>
          <a:xfrm>
            <a:off x="142880" y="103920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id="{2BCBC7F8-56AD-420A-B642-DDFCCF879E99}"/>
              </a:ext>
            </a:extLst>
          </p:cNvPr>
          <p:cNvCxnSpPr/>
          <p:nvPr/>
        </p:nvCxnSpPr>
        <p:spPr>
          <a:xfrm>
            <a:off x="142880" y="1175961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F31FB4F4-EE29-405F-9F15-4AD31D801D43}"/>
              </a:ext>
            </a:extLst>
          </p:cNvPr>
          <p:cNvCxnSpPr/>
          <p:nvPr/>
        </p:nvCxnSpPr>
        <p:spPr>
          <a:xfrm>
            <a:off x="142880" y="1287853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mit Pfeil 63">
            <a:extLst>
              <a:ext uri="{FF2B5EF4-FFF2-40B4-BE49-F238E27FC236}">
                <a16:creationId xmlns:a16="http://schemas.microsoft.com/office/drawing/2014/main" id="{F277B65F-DA3D-45E7-B94F-63DA5283691B}"/>
              </a:ext>
            </a:extLst>
          </p:cNvPr>
          <p:cNvCxnSpPr/>
          <p:nvPr/>
        </p:nvCxnSpPr>
        <p:spPr>
          <a:xfrm>
            <a:off x="142880" y="1399742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mit Pfeil 64">
            <a:extLst>
              <a:ext uri="{FF2B5EF4-FFF2-40B4-BE49-F238E27FC236}">
                <a16:creationId xmlns:a16="http://schemas.microsoft.com/office/drawing/2014/main" id="{E39893FC-41D7-4468-88BA-4EFBA97F0948}"/>
              </a:ext>
            </a:extLst>
          </p:cNvPr>
          <p:cNvCxnSpPr/>
          <p:nvPr/>
        </p:nvCxnSpPr>
        <p:spPr>
          <a:xfrm>
            <a:off x="142880" y="1508530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mit Pfeil 65">
            <a:extLst>
              <a:ext uri="{FF2B5EF4-FFF2-40B4-BE49-F238E27FC236}">
                <a16:creationId xmlns:a16="http://schemas.microsoft.com/office/drawing/2014/main" id="{EC82533E-6CE8-464D-B78A-5475803BE5BB}"/>
              </a:ext>
            </a:extLst>
          </p:cNvPr>
          <p:cNvCxnSpPr/>
          <p:nvPr/>
        </p:nvCxnSpPr>
        <p:spPr>
          <a:xfrm>
            <a:off x="142880" y="162041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mit Pfeil 66">
            <a:extLst>
              <a:ext uri="{FF2B5EF4-FFF2-40B4-BE49-F238E27FC236}">
                <a16:creationId xmlns:a16="http://schemas.microsoft.com/office/drawing/2014/main" id="{0C34FFA8-3517-457A-B229-F27585832A11}"/>
              </a:ext>
            </a:extLst>
          </p:cNvPr>
          <p:cNvCxnSpPr/>
          <p:nvPr/>
        </p:nvCxnSpPr>
        <p:spPr>
          <a:xfrm>
            <a:off x="142880" y="1741630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Gerade Verbindung mit Pfeil 67">
            <a:extLst>
              <a:ext uri="{FF2B5EF4-FFF2-40B4-BE49-F238E27FC236}">
                <a16:creationId xmlns:a16="http://schemas.microsoft.com/office/drawing/2014/main" id="{D696B016-B7F0-499E-8D9C-D3BF83B5930A}"/>
              </a:ext>
            </a:extLst>
          </p:cNvPr>
          <p:cNvCxnSpPr/>
          <p:nvPr/>
        </p:nvCxnSpPr>
        <p:spPr>
          <a:xfrm>
            <a:off x="142880" y="185973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>
            <a:extLst>
              <a:ext uri="{FF2B5EF4-FFF2-40B4-BE49-F238E27FC236}">
                <a16:creationId xmlns:a16="http://schemas.microsoft.com/office/drawing/2014/main" id="{C46BC46F-8C5E-4C8F-B254-67538D172CAE}"/>
              </a:ext>
            </a:extLst>
          </p:cNvPr>
          <p:cNvCxnSpPr/>
          <p:nvPr/>
        </p:nvCxnSpPr>
        <p:spPr>
          <a:xfrm>
            <a:off x="142880" y="197473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mit Pfeil 69">
            <a:extLst>
              <a:ext uri="{FF2B5EF4-FFF2-40B4-BE49-F238E27FC236}">
                <a16:creationId xmlns:a16="http://schemas.microsoft.com/office/drawing/2014/main" id="{CC7D6D17-758B-4FA5-9754-510F183F1683}"/>
              </a:ext>
            </a:extLst>
          </p:cNvPr>
          <p:cNvCxnSpPr/>
          <p:nvPr/>
        </p:nvCxnSpPr>
        <p:spPr>
          <a:xfrm>
            <a:off x="142880" y="208662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0AF6456D-59F9-4329-BD35-D145C659960C}"/>
              </a:ext>
            </a:extLst>
          </p:cNvPr>
          <p:cNvCxnSpPr/>
          <p:nvPr/>
        </p:nvCxnSpPr>
        <p:spPr>
          <a:xfrm>
            <a:off x="142880" y="2210953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554B8620-6E82-4486-99E3-26DE67C51A76}"/>
              </a:ext>
            </a:extLst>
          </p:cNvPr>
          <p:cNvCxnSpPr/>
          <p:nvPr/>
        </p:nvCxnSpPr>
        <p:spPr>
          <a:xfrm>
            <a:off x="142880" y="2329057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 Verbindung mit Pfeil 72">
            <a:extLst>
              <a:ext uri="{FF2B5EF4-FFF2-40B4-BE49-F238E27FC236}">
                <a16:creationId xmlns:a16="http://schemas.microsoft.com/office/drawing/2014/main" id="{4F32E7EF-D6FD-4E4E-BA4E-23843D46D108}"/>
              </a:ext>
            </a:extLst>
          </p:cNvPr>
          <p:cNvCxnSpPr/>
          <p:nvPr/>
        </p:nvCxnSpPr>
        <p:spPr>
          <a:xfrm>
            <a:off x="142880" y="2437846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 Verbindung mit Pfeil 73">
            <a:extLst>
              <a:ext uri="{FF2B5EF4-FFF2-40B4-BE49-F238E27FC236}">
                <a16:creationId xmlns:a16="http://schemas.microsoft.com/office/drawing/2014/main" id="{309A9FE9-002B-426E-9249-6E4D4FCA843D}"/>
              </a:ext>
            </a:extLst>
          </p:cNvPr>
          <p:cNvCxnSpPr/>
          <p:nvPr/>
        </p:nvCxnSpPr>
        <p:spPr>
          <a:xfrm>
            <a:off x="142880" y="2562162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 Verbindung mit Pfeil 74">
            <a:extLst>
              <a:ext uri="{FF2B5EF4-FFF2-40B4-BE49-F238E27FC236}">
                <a16:creationId xmlns:a16="http://schemas.microsoft.com/office/drawing/2014/main" id="{C476570E-6CBB-4691-88D1-1935FA7D69F4}"/>
              </a:ext>
            </a:extLst>
          </p:cNvPr>
          <p:cNvCxnSpPr/>
          <p:nvPr/>
        </p:nvCxnSpPr>
        <p:spPr>
          <a:xfrm>
            <a:off x="142880" y="267405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 Verbindung mit Pfeil 75">
            <a:extLst>
              <a:ext uri="{FF2B5EF4-FFF2-40B4-BE49-F238E27FC236}">
                <a16:creationId xmlns:a16="http://schemas.microsoft.com/office/drawing/2014/main" id="{68E6BD55-B207-401D-A6BA-AADCC8284BD0}"/>
              </a:ext>
            </a:extLst>
          </p:cNvPr>
          <p:cNvCxnSpPr/>
          <p:nvPr/>
        </p:nvCxnSpPr>
        <p:spPr>
          <a:xfrm>
            <a:off x="142880" y="2795271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 Verbindung mit Pfeil 76">
            <a:extLst>
              <a:ext uri="{FF2B5EF4-FFF2-40B4-BE49-F238E27FC236}">
                <a16:creationId xmlns:a16="http://schemas.microsoft.com/office/drawing/2014/main" id="{8B83EBA6-775B-41A2-8076-0C8814675BEF}"/>
              </a:ext>
            </a:extLst>
          </p:cNvPr>
          <p:cNvCxnSpPr/>
          <p:nvPr/>
        </p:nvCxnSpPr>
        <p:spPr>
          <a:xfrm>
            <a:off x="142880" y="291337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 Verbindung mit Pfeil 77">
            <a:extLst>
              <a:ext uri="{FF2B5EF4-FFF2-40B4-BE49-F238E27FC236}">
                <a16:creationId xmlns:a16="http://schemas.microsoft.com/office/drawing/2014/main" id="{801A1E31-249F-47DA-8D83-0BCB7F0F0FFB}"/>
              </a:ext>
            </a:extLst>
          </p:cNvPr>
          <p:cNvCxnSpPr/>
          <p:nvPr/>
        </p:nvCxnSpPr>
        <p:spPr>
          <a:xfrm>
            <a:off x="142880" y="302837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 Verbindung mit Pfeil 78">
            <a:extLst>
              <a:ext uri="{FF2B5EF4-FFF2-40B4-BE49-F238E27FC236}">
                <a16:creationId xmlns:a16="http://schemas.microsoft.com/office/drawing/2014/main" id="{835D2CC4-CC23-417D-8EDA-A92D51D4F1EA}"/>
              </a:ext>
            </a:extLst>
          </p:cNvPr>
          <p:cNvCxnSpPr/>
          <p:nvPr/>
        </p:nvCxnSpPr>
        <p:spPr>
          <a:xfrm>
            <a:off x="142880" y="314026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 Verbindung mit Pfeil 79">
            <a:extLst>
              <a:ext uri="{FF2B5EF4-FFF2-40B4-BE49-F238E27FC236}">
                <a16:creationId xmlns:a16="http://schemas.microsoft.com/office/drawing/2014/main" id="{87638645-9CE5-48F4-B33A-5C3DF1566D70}"/>
              </a:ext>
            </a:extLst>
          </p:cNvPr>
          <p:cNvCxnSpPr/>
          <p:nvPr/>
        </p:nvCxnSpPr>
        <p:spPr>
          <a:xfrm>
            <a:off x="142880" y="3264594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 Verbindung mit Pfeil 80">
            <a:extLst>
              <a:ext uri="{FF2B5EF4-FFF2-40B4-BE49-F238E27FC236}">
                <a16:creationId xmlns:a16="http://schemas.microsoft.com/office/drawing/2014/main" id="{788FF16D-D91C-4E7A-A326-D5A2842B9F4A}"/>
              </a:ext>
            </a:extLst>
          </p:cNvPr>
          <p:cNvCxnSpPr/>
          <p:nvPr/>
        </p:nvCxnSpPr>
        <p:spPr>
          <a:xfrm>
            <a:off x="142880" y="3382697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 Verbindung mit Pfeil 81">
            <a:extLst>
              <a:ext uri="{FF2B5EF4-FFF2-40B4-BE49-F238E27FC236}">
                <a16:creationId xmlns:a16="http://schemas.microsoft.com/office/drawing/2014/main" id="{C5B73A38-4FE6-495A-B8E9-C3361880441C}"/>
              </a:ext>
            </a:extLst>
          </p:cNvPr>
          <p:cNvCxnSpPr/>
          <p:nvPr/>
        </p:nvCxnSpPr>
        <p:spPr>
          <a:xfrm>
            <a:off x="142880" y="3491487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 Verbindung mit Pfeil 82">
            <a:extLst>
              <a:ext uri="{FF2B5EF4-FFF2-40B4-BE49-F238E27FC236}">
                <a16:creationId xmlns:a16="http://schemas.microsoft.com/office/drawing/2014/main" id="{42629F1A-6340-46F2-A635-BBB1DF583FD9}"/>
              </a:ext>
            </a:extLst>
          </p:cNvPr>
          <p:cNvCxnSpPr/>
          <p:nvPr/>
        </p:nvCxnSpPr>
        <p:spPr>
          <a:xfrm>
            <a:off x="142880" y="3615803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mit Pfeil 83">
            <a:extLst>
              <a:ext uri="{FF2B5EF4-FFF2-40B4-BE49-F238E27FC236}">
                <a16:creationId xmlns:a16="http://schemas.microsoft.com/office/drawing/2014/main" id="{BCA9862B-EB07-4AF8-B28F-8E62640A0FBF}"/>
              </a:ext>
            </a:extLst>
          </p:cNvPr>
          <p:cNvCxnSpPr/>
          <p:nvPr/>
        </p:nvCxnSpPr>
        <p:spPr>
          <a:xfrm>
            <a:off x="145991" y="3730801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84">
            <a:extLst>
              <a:ext uri="{FF2B5EF4-FFF2-40B4-BE49-F238E27FC236}">
                <a16:creationId xmlns:a16="http://schemas.microsoft.com/office/drawing/2014/main" id="{0A769BDF-A5EC-4B3A-A0C4-6C3A772B7681}"/>
              </a:ext>
            </a:extLst>
          </p:cNvPr>
          <p:cNvCxnSpPr/>
          <p:nvPr/>
        </p:nvCxnSpPr>
        <p:spPr>
          <a:xfrm>
            <a:off x="145991" y="384890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85">
            <a:extLst>
              <a:ext uri="{FF2B5EF4-FFF2-40B4-BE49-F238E27FC236}">
                <a16:creationId xmlns:a16="http://schemas.microsoft.com/office/drawing/2014/main" id="{0577C6EA-F0CC-4CDA-A69E-E8F2A4CA112A}"/>
              </a:ext>
            </a:extLst>
          </p:cNvPr>
          <p:cNvCxnSpPr/>
          <p:nvPr/>
        </p:nvCxnSpPr>
        <p:spPr>
          <a:xfrm>
            <a:off x="145991" y="396390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mit Pfeil 86">
            <a:extLst>
              <a:ext uri="{FF2B5EF4-FFF2-40B4-BE49-F238E27FC236}">
                <a16:creationId xmlns:a16="http://schemas.microsoft.com/office/drawing/2014/main" id="{B855EF26-2A36-4CC0-8973-FEF51E6165E5}"/>
              </a:ext>
            </a:extLst>
          </p:cNvPr>
          <p:cNvCxnSpPr/>
          <p:nvPr/>
        </p:nvCxnSpPr>
        <p:spPr>
          <a:xfrm>
            <a:off x="145991" y="407579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Gerade Verbindung mit Pfeil 87">
            <a:extLst>
              <a:ext uri="{FF2B5EF4-FFF2-40B4-BE49-F238E27FC236}">
                <a16:creationId xmlns:a16="http://schemas.microsoft.com/office/drawing/2014/main" id="{66D90620-75D2-4E5F-A645-1880D76FED87}"/>
              </a:ext>
            </a:extLst>
          </p:cNvPr>
          <p:cNvCxnSpPr/>
          <p:nvPr/>
        </p:nvCxnSpPr>
        <p:spPr>
          <a:xfrm>
            <a:off x="145991" y="4200124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 Verbindung mit Pfeil 88">
            <a:extLst>
              <a:ext uri="{FF2B5EF4-FFF2-40B4-BE49-F238E27FC236}">
                <a16:creationId xmlns:a16="http://schemas.microsoft.com/office/drawing/2014/main" id="{7BE0FCC0-DDF8-47CE-82D1-EA26B7DF81EC}"/>
              </a:ext>
            </a:extLst>
          </p:cNvPr>
          <p:cNvCxnSpPr/>
          <p:nvPr/>
        </p:nvCxnSpPr>
        <p:spPr>
          <a:xfrm>
            <a:off x="145991" y="4318227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 Verbindung mit Pfeil 89">
            <a:extLst>
              <a:ext uri="{FF2B5EF4-FFF2-40B4-BE49-F238E27FC236}">
                <a16:creationId xmlns:a16="http://schemas.microsoft.com/office/drawing/2014/main" id="{F8F173C2-6CBA-4354-B8EE-A8B78798069E}"/>
              </a:ext>
            </a:extLst>
          </p:cNvPr>
          <p:cNvCxnSpPr/>
          <p:nvPr/>
        </p:nvCxnSpPr>
        <p:spPr>
          <a:xfrm>
            <a:off x="145991" y="4427017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 Verbindung mit Pfeil 90">
            <a:extLst>
              <a:ext uri="{FF2B5EF4-FFF2-40B4-BE49-F238E27FC236}">
                <a16:creationId xmlns:a16="http://schemas.microsoft.com/office/drawing/2014/main" id="{D940737C-00F6-4E6E-B7CE-40D1EDF3D5F2}"/>
              </a:ext>
            </a:extLst>
          </p:cNvPr>
          <p:cNvCxnSpPr/>
          <p:nvPr/>
        </p:nvCxnSpPr>
        <p:spPr>
          <a:xfrm>
            <a:off x="145991" y="4551333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mit Pfeil 91">
            <a:extLst>
              <a:ext uri="{FF2B5EF4-FFF2-40B4-BE49-F238E27FC236}">
                <a16:creationId xmlns:a16="http://schemas.microsoft.com/office/drawing/2014/main" id="{DA0FCAA9-E2B6-41E7-9EE4-1E6EA2606713}"/>
              </a:ext>
            </a:extLst>
          </p:cNvPr>
          <p:cNvCxnSpPr/>
          <p:nvPr/>
        </p:nvCxnSpPr>
        <p:spPr>
          <a:xfrm>
            <a:off x="145986" y="4669448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 Verbindung mit Pfeil 92">
            <a:extLst>
              <a:ext uri="{FF2B5EF4-FFF2-40B4-BE49-F238E27FC236}">
                <a16:creationId xmlns:a16="http://schemas.microsoft.com/office/drawing/2014/main" id="{80E16BF9-53DB-4D28-80BC-788DFEE79676}"/>
              </a:ext>
            </a:extLst>
          </p:cNvPr>
          <p:cNvCxnSpPr/>
          <p:nvPr/>
        </p:nvCxnSpPr>
        <p:spPr>
          <a:xfrm>
            <a:off x="145986" y="4793764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mit Pfeil 93">
            <a:extLst>
              <a:ext uri="{FF2B5EF4-FFF2-40B4-BE49-F238E27FC236}">
                <a16:creationId xmlns:a16="http://schemas.microsoft.com/office/drawing/2014/main" id="{BBDAAD6D-DD79-419F-97A0-F14DD2FA9333}"/>
              </a:ext>
            </a:extLst>
          </p:cNvPr>
          <p:cNvCxnSpPr/>
          <p:nvPr/>
        </p:nvCxnSpPr>
        <p:spPr>
          <a:xfrm>
            <a:off x="149096" y="4908762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Gerade Verbindung mit Pfeil 94">
            <a:extLst>
              <a:ext uri="{FF2B5EF4-FFF2-40B4-BE49-F238E27FC236}">
                <a16:creationId xmlns:a16="http://schemas.microsoft.com/office/drawing/2014/main" id="{52733A66-F2E3-4FCD-9A86-9ED9D8B5AFD8}"/>
              </a:ext>
            </a:extLst>
          </p:cNvPr>
          <p:cNvCxnSpPr/>
          <p:nvPr/>
        </p:nvCxnSpPr>
        <p:spPr>
          <a:xfrm>
            <a:off x="149096" y="5026870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 Verbindung mit Pfeil 95">
            <a:extLst>
              <a:ext uri="{FF2B5EF4-FFF2-40B4-BE49-F238E27FC236}">
                <a16:creationId xmlns:a16="http://schemas.microsoft.com/office/drawing/2014/main" id="{3ADDBEE9-F400-41A3-9B9A-226D592A2089}"/>
              </a:ext>
            </a:extLst>
          </p:cNvPr>
          <p:cNvCxnSpPr/>
          <p:nvPr/>
        </p:nvCxnSpPr>
        <p:spPr>
          <a:xfrm>
            <a:off x="149096" y="5141871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 Verbindung mit Pfeil 96">
            <a:extLst>
              <a:ext uri="{FF2B5EF4-FFF2-40B4-BE49-F238E27FC236}">
                <a16:creationId xmlns:a16="http://schemas.microsoft.com/office/drawing/2014/main" id="{ED85E8DD-F8BD-40D9-B3AD-1C5748639900}"/>
              </a:ext>
            </a:extLst>
          </p:cNvPr>
          <p:cNvCxnSpPr/>
          <p:nvPr/>
        </p:nvCxnSpPr>
        <p:spPr>
          <a:xfrm>
            <a:off x="149096" y="5253760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 Verbindung mit Pfeil 97">
            <a:extLst>
              <a:ext uri="{FF2B5EF4-FFF2-40B4-BE49-F238E27FC236}">
                <a16:creationId xmlns:a16="http://schemas.microsoft.com/office/drawing/2014/main" id="{2F021841-E928-4A4B-9F7F-C484E31451BC}"/>
              </a:ext>
            </a:extLst>
          </p:cNvPr>
          <p:cNvCxnSpPr/>
          <p:nvPr/>
        </p:nvCxnSpPr>
        <p:spPr>
          <a:xfrm>
            <a:off x="149096" y="5378085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>
            <a:extLst>
              <a:ext uri="{FF2B5EF4-FFF2-40B4-BE49-F238E27FC236}">
                <a16:creationId xmlns:a16="http://schemas.microsoft.com/office/drawing/2014/main" id="{CB61EBB3-8E6A-415D-8BA1-6923AE46530D}"/>
              </a:ext>
            </a:extLst>
          </p:cNvPr>
          <p:cNvCxnSpPr/>
          <p:nvPr/>
        </p:nvCxnSpPr>
        <p:spPr>
          <a:xfrm>
            <a:off x="149096" y="5496189"/>
            <a:ext cx="236214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0" name="Grafik 99" descr="Ein Bild, das Entwurf, Text, Kunst, Design enthält.&#10;&#10;KI-generierte Inhalte können fehlerhaft sein.">
            <a:extLst>
              <a:ext uri="{FF2B5EF4-FFF2-40B4-BE49-F238E27FC236}">
                <a16:creationId xmlns:a16="http://schemas.microsoft.com/office/drawing/2014/main" id="{FB014317-222A-4B2D-BCF6-186DC0AE3F6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29921"/>
          <a:stretch>
            <a:fillRect/>
          </a:stretch>
        </p:blipFill>
        <p:spPr>
          <a:xfrm>
            <a:off x="420757" y="607039"/>
            <a:ext cx="5106520" cy="5047501"/>
          </a:xfrm>
          <a:prstGeom prst="rect">
            <a:avLst/>
          </a:prstGeom>
        </p:spPr>
      </p:pic>
      <p:sp>
        <p:nvSpPr>
          <p:cNvPr id="101" name="Textfeld 100">
            <a:extLst>
              <a:ext uri="{FF2B5EF4-FFF2-40B4-BE49-F238E27FC236}">
                <a16:creationId xmlns:a16="http://schemas.microsoft.com/office/drawing/2014/main" id="{E1E00257-7572-440B-BA95-E09303807F26}"/>
              </a:ext>
            </a:extLst>
          </p:cNvPr>
          <p:cNvSpPr txBox="1"/>
          <p:nvPr/>
        </p:nvSpPr>
        <p:spPr>
          <a:xfrm>
            <a:off x="4958507" y="3549470"/>
            <a:ext cx="1165704" cy="2812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28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put Layer</a:t>
            </a:r>
            <a:endParaRPr lang="en-GB" sz="122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FCADB1D0-AA34-533B-FE12-52A9CC808F7F}"/>
              </a:ext>
            </a:extLst>
          </p:cNvPr>
          <p:cNvSpPr txBox="1"/>
          <p:nvPr/>
        </p:nvSpPr>
        <p:spPr>
          <a:xfrm>
            <a:off x="5690455" y="3969404"/>
            <a:ext cx="5001358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sz="1800" u="sng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Supplementary Figure SF1. Neural network without rheumatological consultation (RC)</a:t>
            </a:r>
            <a:endParaRPr lang="de-DE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</a:rPr>
              <a:t>Visual depiction of our neural network without RC. Input parameters are equivalent to those listed in ST4.</a:t>
            </a:r>
            <a:endParaRPr lang="de-DE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5836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– 2022-Design">
  <a:themeElements>
    <a:clrScheme name="Office 2013 – 2022-Desig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– 2022-Design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– 2022-Design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893</Words>
  <Application>Microsoft Office PowerPoint</Application>
  <PresentationFormat>Benutzerdefiniert</PresentationFormat>
  <Paragraphs>1546</Paragraphs>
  <Slides>5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imes New Roman</vt:lpstr>
      <vt:lpstr>Office 2013 – 2022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Simon Melderis</cp:lastModifiedBy>
  <cp:revision>859</cp:revision>
  <dcterms:created xsi:type="dcterms:W3CDTF">2024-11-13T18:40:25Z</dcterms:created>
  <dcterms:modified xsi:type="dcterms:W3CDTF">2026-01-21T10:08:48Z</dcterms:modified>
</cp:coreProperties>
</file>